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drawings/drawing1.xml" ContentType="application/vnd.openxmlformats-officedocument.drawingml.chartshapes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drawings/drawing2.xml" ContentType="application/vnd.openxmlformats-officedocument.drawingml.chartshapes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drawings/drawing3.xml" ContentType="application/vnd.openxmlformats-officedocument.drawingml.chartshapes+xml"/>
  <Override PartName="/ppt/charts/chart12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3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2"/>
  </p:notesMasterIdLst>
  <p:sldIdLst>
    <p:sldId id="322" r:id="rId5"/>
    <p:sldId id="316" r:id="rId6"/>
    <p:sldId id="323" r:id="rId7"/>
    <p:sldId id="317" r:id="rId8"/>
    <p:sldId id="278" r:id="rId9"/>
    <p:sldId id="265" r:id="rId10"/>
    <p:sldId id="314" r:id="rId11"/>
  </p:sldIdLst>
  <p:sldSz cx="12192000" cy="6858000"/>
  <p:notesSz cx="6808788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CC00"/>
    <a:srgbClr val="CC6600"/>
    <a:srgbClr val="DEA400"/>
    <a:srgbClr val="CC9900"/>
    <a:srgbClr val="009999"/>
    <a:srgbClr val="993366"/>
    <a:srgbClr val="B0EE00"/>
    <a:srgbClr val="990033"/>
    <a:srgbClr val="660033"/>
    <a:srgbClr val="33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988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1742" y="4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athology-Decktop\2017\August\ZR-75-1\QPCR\ZR-75-1-miR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chartUserShapes" Target="../drawings/drawing3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nuigalwayie-my.sharepoint.com/personal/0107667s_universityofgalway_ie/Documents/Documents/sanjeev/MIr-378%20PAPER/manuscript%202023/HCT116%20&amp;%20MCF7%20UPR%20stress%20viabilit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chartUserShapes" Target="../drawings/drawing1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HCT116 cell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666013071895424"/>
          <c:y val="2.5428331875182269E-2"/>
          <c:w val="0.78718496732026144"/>
          <c:h val="0.78165099154272377"/>
        </c:manualLayout>
      </c:layout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TG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1!$B$2:$E$2</c:f>
              <c:numCache>
                <c:formatCode>General</c:formatCode>
                <c:ptCount val="4"/>
                <c:pt idx="0">
                  <c:v>1</c:v>
                </c:pt>
                <c:pt idx="1">
                  <c:v>0.76900000000000002</c:v>
                </c:pt>
                <c:pt idx="2">
                  <c:v>0.26700000000000002</c:v>
                </c:pt>
                <c:pt idx="3">
                  <c:v>9.099999999999999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998-42D4-BC05-B1B478CABF35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T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heet1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1!$B$3:$E$3</c:f>
              <c:numCache>
                <c:formatCode>General</c:formatCode>
                <c:ptCount val="4"/>
                <c:pt idx="0">
                  <c:v>1</c:v>
                </c:pt>
                <c:pt idx="1">
                  <c:v>0.82499999999999996</c:v>
                </c:pt>
                <c:pt idx="2">
                  <c:v>0.34100000000000003</c:v>
                </c:pt>
                <c:pt idx="3">
                  <c:v>0.1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998-42D4-BC05-B1B478CABF35}"/>
            </c:ext>
          </c:extLst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BFA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Sheet1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1!$B$4:$E$4</c:f>
              <c:numCache>
                <c:formatCode>General</c:formatCode>
                <c:ptCount val="4"/>
                <c:pt idx="0">
                  <c:v>1</c:v>
                </c:pt>
                <c:pt idx="1">
                  <c:v>0.55700000000000005</c:v>
                </c:pt>
                <c:pt idx="2">
                  <c:v>0.2</c:v>
                </c:pt>
                <c:pt idx="3">
                  <c:v>7.900000000000000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998-42D4-BC05-B1B478CABF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54079552"/>
        <c:axId val="354079224"/>
      </c:lineChart>
      <c:catAx>
        <c:axId val="354079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4079224"/>
        <c:crosses val="autoZero"/>
        <c:auto val="1"/>
        <c:lblAlgn val="ctr"/>
        <c:lblOffset val="100"/>
        <c:noMultiLvlLbl val="0"/>
      </c:catAx>
      <c:valAx>
        <c:axId val="354079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E"/>
                  <a:t>Absorbance (OD 490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40795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6380249343832018"/>
          <c:y val="0.10243000874890641"/>
          <c:w val="0.23267825896762906"/>
          <c:h val="0.26548935185185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417786379196918"/>
          <c:y val="7.0555555555555552E-2"/>
          <c:w val="0.69408306601848102"/>
          <c:h val="0.652364646464646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K$3</c:f>
              <c:strCache>
                <c:ptCount val="1"/>
                <c:pt idx="0">
                  <c:v>ZR-75-1-miR-CTR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O$3</c:f>
                <c:numCache>
                  <c:formatCode>General</c:formatCode>
                  <c:ptCount val="1"/>
                  <c:pt idx="0">
                    <c:v>5.000000000000000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Sheet1!$L$3</c:f>
              <c:numCache>
                <c:formatCode>0.00</c:formatCode>
                <c:ptCount val="1"/>
                <c:pt idx="0">
                  <c:v>0.999640571433201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29-4636-968D-ED6B3CA259C7}"/>
            </c:ext>
          </c:extLst>
        </c:ser>
        <c:ser>
          <c:idx val="1"/>
          <c:order val="1"/>
          <c:tx>
            <c:strRef>
              <c:f>Sheet1!$K$4</c:f>
              <c:strCache>
                <c:ptCount val="1"/>
                <c:pt idx="0">
                  <c:v>ZR-75-1-miR-378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O$4</c:f>
                <c:numCache>
                  <c:formatCode>General</c:formatCode>
                  <c:ptCount val="1"/>
                  <c:pt idx="0">
                    <c:v>1.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Sheet1!$L$4</c:f>
              <c:numCache>
                <c:formatCode>0.00</c:formatCode>
                <c:ptCount val="1"/>
                <c:pt idx="0">
                  <c:v>71.6907626763073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29-4636-968D-ED6B3CA259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2017856"/>
        <c:axId val="362018248"/>
      </c:barChart>
      <c:catAx>
        <c:axId val="362017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2018248"/>
        <c:crosses val="autoZero"/>
        <c:auto val="1"/>
        <c:lblAlgn val="ctr"/>
        <c:lblOffset val="100"/>
        <c:noMultiLvlLbl val="0"/>
      </c:catAx>
      <c:valAx>
        <c:axId val="3620182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3.5966313543365339E-2"/>
              <c:y val="7.687020202020201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2017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246290355893477"/>
          <c:y val="0.84686161616161615"/>
          <c:w val="0.7514284308157021"/>
          <c:h val="0.14672424242424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576527777777779"/>
          <c:y val="6.4675925925925928E-2"/>
          <c:w val="0.6295587962962963"/>
          <c:h val="0.804806481481481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3</c:f>
              <c:strCache>
                <c:ptCount val="1"/>
                <c:pt idx="0">
                  <c:v>HCT116-miR-CTRL-U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14:$B$19</c:f>
                <c:numCache>
                  <c:formatCode>General</c:formatCode>
                  <c:ptCount val="6"/>
                  <c:pt idx="0">
                    <c:v>2.35565854109554E-4</c:v>
                  </c:pt>
                  <c:pt idx="1">
                    <c:v>9.0681835177558234E-2</c:v>
                  </c:pt>
                  <c:pt idx="2">
                    <c:v>0.91357599994350025</c:v>
                  </c:pt>
                  <c:pt idx="3">
                    <c:v>0.24817649048038165</c:v>
                  </c:pt>
                  <c:pt idx="4">
                    <c:v>0.76368486092893917</c:v>
                  </c:pt>
                  <c:pt idx="5">
                    <c:v>0.235021046925361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</c:f>
              <c:strCache>
                <c:ptCount val="1"/>
                <c:pt idx="0">
                  <c:v>GRP78</c:v>
                </c:pt>
              </c:strCache>
            </c:strRef>
          </c:cat>
          <c:val>
            <c:numRef>
              <c:f>Sheet2!$B$3</c:f>
              <c:numCache>
                <c:formatCode>0.00</c:formatCode>
                <c:ptCount val="1"/>
                <c:pt idx="0">
                  <c:v>1.00024356632248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16-4A71-94A0-4B8257424B32}"/>
            </c:ext>
          </c:extLst>
        </c:ser>
        <c:ser>
          <c:idx val="1"/>
          <c:order val="1"/>
          <c:tx>
            <c:strRef>
              <c:f>Sheet2!$A$4</c:f>
              <c:strCache>
                <c:ptCount val="1"/>
                <c:pt idx="0">
                  <c:v>HCT116-miR-CTRL-BFA-8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15</c:f>
                <c:numCache>
                  <c:formatCode>General</c:formatCode>
                  <c:ptCount val="1"/>
                  <c:pt idx="0">
                    <c:v>9.068183517755823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</c:f>
              <c:strCache>
                <c:ptCount val="1"/>
                <c:pt idx="0">
                  <c:v>GRP78</c:v>
                </c:pt>
              </c:strCache>
            </c:strRef>
          </c:cat>
          <c:val>
            <c:numRef>
              <c:f>Sheet2!$B$4</c:f>
              <c:numCache>
                <c:formatCode>0.00</c:formatCode>
                <c:ptCount val="1"/>
                <c:pt idx="0">
                  <c:v>6.6983248688875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D16-4A71-94A0-4B8257424B32}"/>
            </c:ext>
          </c:extLst>
        </c:ser>
        <c:ser>
          <c:idx val="2"/>
          <c:order val="2"/>
          <c:tx>
            <c:strRef>
              <c:f>Sheet2!$A$5</c:f>
              <c:strCache>
                <c:ptCount val="1"/>
                <c:pt idx="0">
                  <c:v>HCT116-miR-CTRL-BFA-24h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16</c:f>
                <c:numCache>
                  <c:formatCode>General</c:formatCode>
                  <c:ptCount val="1"/>
                  <c:pt idx="0">
                    <c:v>0.913575999943500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</c:f>
              <c:strCache>
                <c:ptCount val="1"/>
                <c:pt idx="0">
                  <c:v>GRP78</c:v>
                </c:pt>
              </c:strCache>
            </c:strRef>
          </c:cat>
          <c:val>
            <c:numRef>
              <c:f>Sheet2!$B$5</c:f>
              <c:numCache>
                <c:formatCode>0.00</c:formatCode>
                <c:ptCount val="1"/>
                <c:pt idx="0">
                  <c:v>14.0235695115497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D16-4A71-94A0-4B8257424B32}"/>
            </c:ext>
          </c:extLst>
        </c:ser>
        <c:ser>
          <c:idx val="3"/>
          <c:order val="3"/>
          <c:tx>
            <c:strRef>
              <c:f>Sheet2!$A$6</c:f>
              <c:strCache>
                <c:ptCount val="1"/>
                <c:pt idx="0">
                  <c:v>HCT116-miR-378-U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17</c:f>
                <c:numCache>
                  <c:formatCode>General</c:formatCode>
                  <c:ptCount val="1"/>
                  <c:pt idx="0">
                    <c:v>0.248176490480381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</c:f>
              <c:strCache>
                <c:ptCount val="1"/>
                <c:pt idx="0">
                  <c:v>GRP78</c:v>
                </c:pt>
              </c:strCache>
            </c:strRef>
          </c:cat>
          <c:val>
            <c:numRef>
              <c:f>Sheet2!$B$6</c:f>
              <c:numCache>
                <c:formatCode>0.00</c:formatCode>
                <c:ptCount val="1"/>
                <c:pt idx="0">
                  <c:v>0.647475074846308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D16-4A71-94A0-4B8257424B32}"/>
            </c:ext>
          </c:extLst>
        </c:ser>
        <c:ser>
          <c:idx val="4"/>
          <c:order val="4"/>
          <c:tx>
            <c:strRef>
              <c:f>Sheet2!$A$7</c:f>
              <c:strCache>
                <c:ptCount val="1"/>
                <c:pt idx="0">
                  <c:v>HCT116-miR-378-BFA-8h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18</c:f>
                <c:numCache>
                  <c:formatCode>General</c:formatCode>
                  <c:ptCount val="1"/>
                  <c:pt idx="0">
                    <c:v>0.763684860928939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</c:f>
              <c:strCache>
                <c:ptCount val="1"/>
                <c:pt idx="0">
                  <c:v>GRP78</c:v>
                </c:pt>
              </c:strCache>
            </c:strRef>
          </c:cat>
          <c:val>
            <c:numRef>
              <c:f>Sheet2!$B$7</c:f>
              <c:numCache>
                <c:formatCode>0.00</c:formatCode>
                <c:ptCount val="1"/>
                <c:pt idx="0">
                  <c:v>6.70577185426317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D16-4A71-94A0-4B8257424B32}"/>
            </c:ext>
          </c:extLst>
        </c:ser>
        <c:ser>
          <c:idx val="5"/>
          <c:order val="5"/>
          <c:tx>
            <c:strRef>
              <c:f>Sheet2!$A$8</c:f>
              <c:strCache>
                <c:ptCount val="1"/>
                <c:pt idx="0">
                  <c:v>HCT116-miR-378-BFA-24h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19</c:f>
                <c:numCache>
                  <c:formatCode>General</c:formatCode>
                  <c:ptCount val="1"/>
                  <c:pt idx="0">
                    <c:v>0.235021046925361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</c:f>
              <c:strCache>
                <c:ptCount val="1"/>
                <c:pt idx="0">
                  <c:v>GRP78</c:v>
                </c:pt>
              </c:strCache>
            </c:strRef>
          </c:cat>
          <c:val>
            <c:numRef>
              <c:f>Sheet2!$B$8</c:f>
              <c:numCache>
                <c:formatCode>0.00</c:formatCode>
                <c:ptCount val="1"/>
                <c:pt idx="0">
                  <c:v>15.622982801069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D16-4A71-94A0-4B8257424B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2019032"/>
        <c:axId val="362018640"/>
      </c:barChart>
      <c:catAx>
        <c:axId val="362019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2018640"/>
        <c:crosses val="autoZero"/>
        <c:auto val="1"/>
        <c:lblAlgn val="ctr"/>
        <c:lblOffset val="100"/>
        <c:noMultiLvlLbl val="0"/>
      </c:catAx>
      <c:valAx>
        <c:axId val="362018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2019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075273224043714"/>
          <c:y val="6.4675925925925928E-2"/>
          <c:w val="0.6356316029143898"/>
          <c:h val="0.82244537037037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23</c:f>
              <c:strCache>
                <c:ptCount val="1"/>
                <c:pt idx="0">
                  <c:v>HCT116-miR-CTRL-U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14</c:f>
                <c:numCache>
                  <c:formatCode>General</c:formatCode>
                  <c:ptCount val="1"/>
                  <c:pt idx="0">
                    <c:v>2.2063867258537151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2</c:f>
              <c:strCache>
                <c:ptCount val="1"/>
                <c:pt idx="0">
                  <c:v>HERP</c:v>
                </c:pt>
              </c:strCache>
            </c:strRef>
          </c:cat>
          <c:val>
            <c:numRef>
              <c:f>Sheet2!$B$23</c:f>
              <c:numCache>
                <c:formatCode>0.00</c:formatCode>
                <c:ptCount val="1"/>
                <c:pt idx="0">
                  <c:v>1.00042635532809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94-4BA3-AFDF-88AA1ABC8871}"/>
            </c:ext>
          </c:extLst>
        </c:ser>
        <c:ser>
          <c:idx val="1"/>
          <c:order val="1"/>
          <c:tx>
            <c:strRef>
              <c:f>Sheet2!$A$24</c:f>
              <c:strCache>
                <c:ptCount val="1"/>
                <c:pt idx="0">
                  <c:v>HCT116-miR-CTRL-BFA-8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15</c:f>
                <c:numCache>
                  <c:formatCode>General</c:formatCode>
                  <c:ptCount val="1"/>
                  <c:pt idx="0">
                    <c:v>1.22758147821620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2</c:f>
              <c:strCache>
                <c:ptCount val="1"/>
                <c:pt idx="0">
                  <c:v>HERP</c:v>
                </c:pt>
              </c:strCache>
            </c:strRef>
          </c:cat>
          <c:val>
            <c:numRef>
              <c:f>Sheet2!$B$24</c:f>
              <c:numCache>
                <c:formatCode>0.00</c:formatCode>
                <c:ptCount val="1"/>
                <c:pt idx="0">
                  <c:v>13.1972941239906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F94-4BA3-AFDF-88AA1ABC8871}"/>
            </c:ext>
          </c:extLst>
        </c:ser>
        <c:ser>
          <c:idx val="2"/>
          <c:order val="2"/>
          <c:tx>
            <c:strRef>
              <c:f>Sheet2!$A$25</c:f>
              <c:strCache>
                <c:ptCount val="1"/>
                <c:pt idx="0">
                  <c:v>HCT116-miR-CTRL-BFA-24h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16</c:f>
                <c:numCache>
                  <c:formatCode>General</c:formatCode>
                  <c:ptCount val="1"/>
                  <c:pt idx="0">
                    <c:v>0.546146645583011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2</c:f>
              <c:strCache>
                <c:ptCount val="1"/>
                <c:pt idx="0">
                  <c:v>HERP</c:v>
                </c:pt>
              </c:strCache>
            </c:strRef>
          </c:cat>
          <c:val>
            <c:numRef>
              <c:f>Sheet2!$B$25</c:f>
              <c:numCache>
                <c:formatCode>0.00</c:formatCode>
                <c:ptCount val="1"/>
                <c:pt idx="0">
                  <c:v>34.1886348109087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F94-4BA3-AFDF-88AA1ABC8871}"/>
            </c:ext>
          </c:extLst>
        </c:ser>
        <c:ser>
          <c:idx val="3"/>
          <c:order val="3"/>
          <c:tx>
            <c:strRef>
              <c:f>Sheet2!$A$26</c:f>
              <c:strCache>
                <c:ptCount val="1"/>
                <c:pt idx="0">
                  <c:v>HCT116-miR-378-U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17</c:f>
                <c:numCache>
                  <c:formatCode>General</c:formatCode>
                  <c:ptCount val="1"/>
                  <c:pt idx="0">
                    <c:v>0.215534675383352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2</c:f>
              <c:strCache>
                <c:ptCount val="1"/>
                <c:pt idx="0">
                  <c:v>HERP</c:v>
                </c:pt>
              </c:strCache>
            </c:strRef>
          </c:cat>
          <c:val>
            <c:numRef>
              <c:f>Sheet2!$B$26</c:f>
              <c:numCache>
                <c:formatCode>0.00</c:formatCode>
                <c:ptCount val="1"/>
                <c:pt idx="0">
                  <c:v>0.80359766050128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F94-4BA3-AFDF-88AA1ABC8871}"/>
            </c:ext>
          </c:extLst>
        </c:ser>
        <c:ser>
          <c:idx val="4"/>
          <c:order val="4"/>
          <c:tx>
            <c:strRef>
              <c:f>Sheet2!$A$27</c:f>
              <c:strCache>
                <c:ptCount val="1"/>
                <c:pt idx="0">
                  <c:v>HCT116-miR-378-BFA-8h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18</c:f>
                <c:numCache>
                  <c:formatCode>General</c:formatCode>
                  <c:ptCount val="1"/>
                  <c:pt idx="0">
                    <c:v>7.673196444118612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2</c:f>
              <c:strCache>
                <c:ptCount val="1"/>
                <c:pt idx="0">
                  <c:v>HERP</c:v>
                </c:pt>
              </c:strCache>
            </c:strRef>
          </c:cat>
          <c:val>
            <c:numRef>
              <c:f>Sheet2!$B$27</c:f>
              <c:numCache>
                <c:formatCode>0.00</c:formatCode>
                <c:ptCount val="1"/>
                <c:pt idx="0">
                  <c:v>10.099485923910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F94-4BA3-AFDF-88AA1ABC8871}"/>
            </c:ext>
          </c:extLst>
        </c:ser>
        <c:ser>
          <c:idx val="5"/>
          <c:order val="5"/>
          <c:tx>
            <c:strRef>
              <c:f>Sheet2!$A$28</c:f>
              <c:strCache>
                <c:ptCount val="1"/>
                <c:pt idx="0">
                  <c:v>HCT116-miR-378-BFA-24h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19</c:f>
                <c:numCache>
                  <c:formatCode>General</c:formatCode>
                  <c:ptCount val="1"/>
                  <c:pt idx="0">
                    <c:v>2.78578530235423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2</c:f>
              <c:strCache>
                <c:ptCount val="1"/>
                <c:pt idx="0">
                  <c:v>HERP</c:v>
                </c:pt>
              </c:strCache>
            </c:strRef>
          </c:cat>
          <c:val>
            <c:numRef>
              <c:f>Sheet2!$B$28</c:f>
              <c:numCache>
                <c:formatCode>0.00</c:formatCode>
                <c:ptCount val="1"/>
                <c:pt idx="0">
                  <c:v>35.085726458322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F94-4BA3-AFDF-88AA1ABC88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0804336"/>
        <c:axId val="400804728"/>
      </c:barChart>
      <c:catAx>
        <c:axId val="400804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804728"/>
        <c:crosses val="autoZero"/>
        <c:auto val="1"/>
        <c:lblAlgn val="ctr"/>
        <c:lblOffset val="100"/>
        <c:noMultiLvlLbl val="0"/>
      </c:catAx>
      <c:valAx>
        <c:axId val="4008047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804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43648014930623"/>
          <c:y val="6.3615664845173045E-2"/>
          <c:w val="0.37409997726085514"/>
          <c:h val="0.802223132969034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31</c:f>
              <c:strCache>
                <c:ptCount val="1"/>
                <c:pt idx="0">
                  <c:v>HCT116-miR-CTRL-U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D$14</c:f>
                <c:numCache>
                  <c:formatCode>General</c:formatCode>
                  <c:ptCount val="1"/>
                  <c:pt idx="0">
                    <c:v>7.4694044000289672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0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B$31</c:f>
              <c:numCache>
                <c:formatCode>0.00</c:formatCode>
                <c:ptCount val="1"/>
                <c:pt idx="0">
                  <c:v>0.999995706117536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91-49B8-8A4A-F5C48753AA45}"/>
            </c:ext>
          </c:extLst>
        </c:ser>
        <c:ser>
          <c:idx val="1"/>
          <c:order val="1"/>
          <c:tx>
            <c:strRef>
              <c:f>Sheet2!$A$32</c:f>
              <c:strCache>
                <c:ptCount val="1"/>
                <c:pt idx="0">
                  <c:v>HCT116-miR-CTRL-BFA-8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D$15</c:f>
                <c:numCache>
                  <c:formatCode>General</c:formatCode>
                  <c:ptCount val="1"/>
                  <c:pt idx="0">
                    <c:v>3.93416306254251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0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B$32</c:f>
              <c:numCache>
                <c:formatCode>0.00</c:formatCode>
                <c:ptCount val="1"/>
                <c:pt idx="0">
                  <c:v>20.567932789868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991-49B8-8A4A-F5C48753AA45}"/>
            </c:ext>
          </c:extLst>
        </c:ser>
        <c:ser>
          <c:idx val="2"/>
          <c:order val="2"/>
          <c:tx>
            <c:strRef>
              <c:f>Sheet2!$A$33</c:f>
              <c:strCache>
                <c:ptCount val="1"/>
                <c:pt idx="0">
                  <c:v>HCT116-miR-CTRL-BFA-24h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19</c:f>
                <c:numCache>
                  <c:formatCode>General</c:formatCode>
                  <c:ptCount val="1"/>
                  <c:pt idx="0">
                    <c:v>2.78578530235423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0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B$33</c:f>
              <c:numCache>
                <c:formatCode>0.00</c:formatCode>
                <c:ptCount val="1"/>
                <c:pt idx="0">
                  <c:v>62.0773744389183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991-49B8-8A4A-F5C48753AA45}"/>
            </c:ext>
          </c:extLst>
        </c:ser>
        <c:ser>
          <c:idx val="3"/>
          <c:order val="3"/>
          <c:tx>
            <c:strRef>
              <c:f>Sheet2!$A$34</c:f>
              <c:strCache>
                <c:ptCount val="1"/>
                <c:pt idx="0">
                  <c:v>HCT116-miR-378-U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D$17</c:f>
                <c:numCache>
                  <c:formatCode>General</c:formatCode>
                  <c:ptCount val="1"/>
                  <c:pt idx="0">
                    <c:v>1.294636317827269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0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B$34</c:f>
              <c:numCache>
                <c:formatCode>0.00</c:formatCode>
                <c:ptCount val="1"/>
                <c:pt idx="0">
                  <c:v>0.954015677495467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991-49B8-8A4A-F5C48753AA45}"/>
            </c:ext>
          </c:extLst>
        </c:ser>
        <c:ser>
          <c:idx val="4"/>
          <c:order val="4"/>
          <c:tx>
            <c:strRef>
              <c:f>Sheet2!$A$35</c:f>
              <c:strCache>
                <c:ptCount val="1"/>
                <c:pt idx="0">
                  <c:v>HCT116-miR-378-BFA-8h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D$18</c:f>
                <c:numCache>
                  <c:formatCode>General</c:formatCode>
                  <c:ptCount val="1"/>
                  <c:pt idx="0">
                    <c:v>4.06429850437471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0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B$35</c:f>
              <c:numCache>
                <c:formatCode>0.00</c:formatCode>
                <c:ptCount val="1"/>
                <c:pt idx="0">
                  <c:v>19.2207407594578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991-49B8-8A4A-F5C48753AA45}"/>
            </c:ext>
          </c:extLst>
        </c:ser>
        <c:ser>
          <c:idx val="5"/>
          <c:order val="5"/>
          <c:tx>
            <c:strRef>
              <c:f>Sheet2!$A$36</c:f>
              <c:strCache>
                <c:ptCount val="1"/>
                <c:pt idx="0">
                  <c:v>HCT116-miR-378-BFA-24h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D$15</c:f>
                <c:numCache>
                  <c:formatCode>General</c:formatCode>
                  <c:ptCount val="1"/>
                  <c:pt idx="0">
                    <c:v>3.93416306254251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0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B$36</c:f>
              <c:numCache>
                <c:formatCode>0.00</c:formatCode>
                <c:ptCount val="1"/>
                <c:pt idx="0">
                  <c:v>60.656033805010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991-49B8-8A4A-F5C48753AA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0805512"/>
        <c:axId val="400805904"/>
      </c:barChart>
      <c:catAx>
        <c:axId val="400805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805904"/>
        <c:crosses val="autoZero"/>
        <c:auto val="1"/>
        <c:lblAlgn val="ctr"/>
        <c:lblOffset val="100"/>
        <c:noMultiLvlLbl val="0"/>
      </c:catAx>
      <c:valAx>
        <c:axId val="4008059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08055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864168172189479"/>
          <c:y val="0.20891165755919855"/>
          <c:w val="0.40320661929801277"/>
          <c:h val="0.468753280839895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CF7 cell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940833333333333"/>
          <c:y val="2.5428331875182269E-2"/>
          <c:w val="0.8044368686868687"/>
          <c:h val="0.78628062117235342"/>
        </c:manualLayout>
      </c:layout>
      <c:lineChart>
        <c:grouping val="standard"/>
        <c:varyColors val="0"/>
        <c:ser>
          <c:idx val="0"/>
          <c:order val="0"/>
          <c:tx>
            <c:strRef>
              <c:f>Sheet2!$A$2</c:f>
              <c:strCache>
                <c:ptCount val="1"/>
                <c:pt idx="0">
                  <c:v>TG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2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2!$B$2:$E$2</c:f>
              <c:numCache>
                <c:formatCode>General</c:formatCode>
                <c:ptCount val="4"/>
                <c:pt idx="0">
                  <c:v>1</c:v>
                </c:pt>
                <c:pt idx="1">
                  <c:v>0.77300000000000002</c:v>
                </c:pt>
                <c:pt idx="2">
                  <c:v>0.40899999999999997</c:v>
                </c:pt>
                <c:pt idx="3">
                  <c:v>0.2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C0A-4EBF-ADA0-30BFDCA9A1B8}"/>
            </c:ext>
          </c:extLst>
        </c:ser>
        <c:ser>
          <c:idx val="1"/>
          <c:order val="1"/>
          <c:tx>
            <c:strRef>
              <c:f>Sheet2!$A$3</c:f>
              <c:strCache>
                <c:ptCount val="1"/>
                <c:pt idx="0">
                  <c:v>T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heet2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2!$B$3:$E$3</c:f>
              <c:numCache>
                <c:formatCode>General</c:formatCode>
                <c:ptCount val="4"/>
                <c:pt idx="0">
                  <c:v>1</c:v>
                </c:pt>
                <c:pt idx="1">
                  <c:v>0.93</c:v>
                </c:pt>
                <c:pt idx="2">
                  <c:v>0.73499999999999999</c:v>
                </c:pt>
                <c:pt idx="3">
                  <c:v>0.611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C0A-4EBF-ADA0-30BFDCA9A1B8}"/>
            </c:ext>
          </c:extLst>
        </c:ser>
        <c:ser>
          <c:idx val="2"/>
          <c:order val="2"/>
          <c:tx>
            <c:strRef>
              <c:f>Sheet2!$A$4</c:f>
              <c:strCache>
                <c:ptCount val="1"/>
                <c:pt idx="0">
                  <c:v>BFA</c:v>
                </c:pt>
              </c:strCache>
            </c:strRef>
          </c:tx>
          <c:spPr>
            <a:ln w="28575" cap="sq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Sheet2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2!$B$4:$E$4</c:f>
              <c:numCache>
                <c:formatCode>General</c:formatCode>
                <c:ptCount val="4"/>
                <c:pt idx="0">
                  <c:v>1</c:v>
                </c:pt>
                <c:pt idx="1">
                  <c:v>0.51800000000000002</c:v>
                </c:pt>
                <c:pt idx="2">
                  <c:v>0.223</c:v>
                </c:pt>
                <c:pt idx="3">
                  <c:v>0.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C0A-4EBF-ADA0-30BFDCA9A1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71440656"/>
        <c:axId val="271438032"/>
      </c:lineChart>
      <c:catAx>
        <c:axId val="271440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1438032"/>
        <c:crosses val="autoZero"/>
        <c:auto val="1"/>
        <c:lblAlgn val="ctr"/>
        <c:lblOffset val="100"/>
        <c:noMultiLvlLbl val="0"/>
      </c:catAx>
      <c:valAx>
        <c:axId val="271438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E"/>
                  <a:t>Absorbance (OD 490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1440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6658027121609795"/>
          <c:y val="6.5392971711869349E-2"/>
          <c:w val="0.22517279090113737"/>
          <c:h val="0.241682870370370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RKO cell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159313725490195"/>
          <c:y val="4.306851851851852E-2"/>
          <c:w val="0.78785130718954244"/>
          <c:h val="0.78790092592592598"/>
        </c:manualLayout>
      </c:layout>
      <c:lineChart>
        <c:grouping val="standard"/>
        <c:varyColors val="0"/>
        <c:ser>
          <c:idx val="0"/>
          <c:order val="0"/>
          <c:tx>
            <c:strRef>
              <c:f>Sheet3!$A$2</c:f>
              <c:strCache>
                <c:ptCount val="1"/>
                <c:pt idx="0">
                  <c:v>TG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3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3!$B$2:$E$2</c:f>
              <c:numCache>
                <c:formatCode>General</c:formatCode>
                <c:ptCount val="4"/>
                <c:pt idx="0">
                  <c:v>1</c:v>
                </c:pt>
                <c:pt idx="1">
                  <c:v>0.86899999999999999</c:v>
                </c:pt>
                <c:pt idx="2">
                  <c:v>0.66700000000000004</c:v>
                </c:pt>
                <c:pt idx="3">
                  <c:v>0.391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D84-4EDE-8D15-AD6C0DE639EB}"/>
            </c:ext>
          </c:extLst>
        </c:ser>
        <c:ser>
          <c:idx val="1"/>
          <c:order val="1"/>
          <c:tx>
            <c:strRef>
              <c:f>Sheet3!$A$3</c:f>
              <c:strCache>
                <c:ptCount val="1"/>
                <c:pt idx="0">
                  <c:v>T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heet3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3!$B$3:$E$3</c:f>
              <c:numCache>
                <c:formatCode>General</c:formatCode>
                <c:ptCount val="4"/>
                <c:pt idx="0">
                  <c:v>1</c:v>
                </c:pt>
                <c:pt idx="1">
                  <c:v>0.78249999999999997</c:v>
                </c:pt>
                <c:pt idx="2">
                  <c:v>0.54100000000000004</c:v>
                </c:pt>
                <c:pt idx="3">
                  <c:v>0.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D84-4EDE-8D15-AD6C0DE639EB}"/>
            </c:ext>
          </c:extLst>
        </c:ser>
        <c:ser>
          <c:idx val="2"/>
          <c:order val="2"/>
          <c:tx>
            <c:strRef>
              <c:f>Sheet3!$A$4</c:f>
              <c:strCache>
                <c:ptCount val="1"/>
                <c:pt idx="0">
                  <c:v>BFA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Sheet3!$B$1:$E$1</c:f>
              <c:strCache>
                <c:ptCount val="4"/>
                <c:pt idx="0">
                  <c:v>Day 0</c:v>
                </c:pt>
                <c:pt idx="1">
                  <c:v>Day 1</c:v>
                </c:pt>
                <c:pt idx="2">
                  <c:v>Day 2</c:v>
                </c:pt>
                <c:pt idx="3">
                  <c:v>Day 3</c:v>
                </c:pt>
              </c:strCache>
            </c:strRef>
          </c:cat>
          <c:val>
            <c:numRef>
              <c:f>Sheet3!$B$4:$E$4</c:f>
              <c:numCache>
                <c:formatCode>General</c:formatCode>
                <c:ptCount val="4"/>
                <c:pt idx="0">
                  <c:v>1</c:v>
                </c:pt>
                <c:pt idx="1">
                  <c:v>0.60699999999999998</c:v>
                </c:pt>
                <c:pt idx="2">
                  <c:v>0.32</c:v>
                </c:pt>
                <c:pt idx="3">
                  <c:v>0.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D84-4EDE-8D15-AD6C0DE639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13742536"/>
        <c:axId val="513749096"/>
      </c:lineChart>
      <c:catAx>
        <c:axId val="513742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3749096"/>
        <c:crosses val="autoZero"/>
        <c:auto val="1"/>
        <c:lblAlgn val="ctr"/>
        <c:lblOffset val="100"/>
        <c:noMultiLvlLbl val="0"/>
      </c:catAx>
      <c:valAx>
        <c:axId val="5137490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E"/>
                  <a:t>Absorbance (OD 490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3742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3247484689413833"/>
          <c:y val="6.2483595800524948E-2"/>
          <c:w val="0.22393919510061244"/>
          <c:h val="0.210664552347623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775972222222222"/>
          <c:y val="3.2238325594378961E-2"/>
          <c:w val="0.53804372427983538"/>
          <c:h val="0.551513888888888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90717-PLKO-MIRNAS'!$N$126</c:f>
              <c:strCache>
                <c:ptCount val="1"/>
                <c:pt idx="0">
                  <c:v>HCT116-PLKO-U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26</c:f>
                <c:numCache>
                  <c:formatCode>General</c:formatCode>
                  <c:ptCount val="1"/>
                  <c:pt idx="0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25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26</c:f>
              <c:numCache>
                <c:formatCode>0.00</c:formatCode>
                <c:ptCount val="1"/>
                <c:pt idx="0">
                  <c:v>1.00045265220498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FE-45F5-8FB9-746836D864D2}"/>
            </c:ext>
          </c:extLst>
        </c:ser>
        <c:ser>
          <c:idx val="1"/>
          <c:order val="1"/>
          <c:tx>
            <c:strRef>
              <c:f>'[Chart in Microsoft PowerPoint]290717-PLKO-MIRNAS'!$N$127</c:f>
              <c:strCache>
                <c:ptCount val="1"/>
                <c:pt idx="0">
                  <c:v>HCT116-PLKO-BFA-24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27</c:f>
                <c:numCache>
                  <c:formatCode>General</c:formatCode>
                  <c:ptCount val="1"/>
                  <c:pt idx="0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25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27</c:f>
              <c:numCache>
                <c:formatCode>0.00</c:formatCode>
                <c:ptCount val="1"/>
                <c:pt idx="0">
                  <c:v>0.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FE-45F5-8FB9-746836D864D2}"/>
            </c:ext>
          </c:extLst>
        </c:ser>
        <c:ser>
          <c:idx val="2"/>
          <c:order val="2"/>
          <c:tx>
            <c:strRef>
              <c:f>'[Chart in Microsoft PowerPoint]290717-PLKO-MIRNAS'!$N$128</c:f>
              <c:strCache>
                <c:ptCount val="1"/>
                <c:pt idx="0">
                  <c:v>HCT116-ATF6-KD-Un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28</c:f>
                <c:numCache>
                  <c:formatCode>General</c:formatCode>
                  <c:ptCount val="1"/>
                  <c:pt idx="0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25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28</c:f>
              <c:numCache>
                <c:formatCode>0.00</c:formatCode>
                <c:ptCount val="1"/>
                <c:pt idx="0">
                  <c:v>1.11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EFE-45F5-8FB9-746836D864D2}"/>
            </c:ext>
          </c:extLst>
        </c:ser>
        <c:ser>
          <c:idx val="3"/>
          <c:order val="3"/>
          <c:tx>
            <c:strRef>
              <c:f>'[Chart in Microsoft PowerPoint]290717-PLKO-MIRNAS'!$N$129</c:f>
              <c:strCache>
                <c:ptCount val="1"/>
                <c:pt idx="0">
                  <c:v>HCT116-ATF6-KD-BFA-24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29</c:f>
                <c:numCache>
                  <c:formatCode>General</c:formatCode>
                  <c:ptCount val="1"/>
                  <c:pt idx="0">
                    <c:v>0.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25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29</c:f>
              <c:numCache>
                <c:formatCode>0.00</c:formatCode>
                <c:ptCount val="1"/>
                <c:pt idx="0">
                  <c:v>0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EFE-45F5-8FB9-746836D864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6836248"/>
        <c:axId val="125478440"/>
      </c:barChart>
      <c:catAx>
        <c:axId val="276836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5478440"/>
        <c:crosses val="autoZero"/>
        <c:auto val="1"/>
        <c:lblAlgn val="ctr"/>
        <c:lblOffset val="100"/>
        <c:noMultiLvlLbl val="0"/>
      </c:catAx>
      <c:valAx>
        <c:axId val="1254784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3.7858024691358023E-2"/>
              <c:y val="5.670972222222222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68362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0138374485596707E-2"/>
          <c:y val="0.70676595821380583"/>
          <c:w val="0.96665689300411506"/>
          <c:h val="0.291956896551724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973919753086418"/>
          <c:y val="3.2293981481481479E-2"/>
          <c:w val="0.57533281893004118"/>
          <c:h val="0.551979629629629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90717-PLKO-MIRNAS'!$N$118</c:f>
              <c:strCache>
                <c:ptCount val="1"/>
                <c:pt idx="0">
                  <c:v>HCT116-PLKO-U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18</c:f>
                <c:numCache>
                  <c:formatCode>General</c:formatCode>
                  <c:ptCount val="1"/>
                  <c:pt idx="0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7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18</c:f>
              <c:numCache>
                <c:formatCode>0.00</c:formatCode>
                <c:ptCount val="1"/>
                <c:pt idx="0">
                  <c:v>1.00045265220498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CB-417B-8B20-5E07A7AED977}"/>
            </c:ext>
          </c:extLst>
        </c:ser>
        <c:ser>
          <c:idx val="1"/>
          <c:order val="1"/>
          <c:tx>
            <c:strRef>
              <c:f>'[Chart in Microsoft PowerPoint]290717-PLKO-MIRNAS'!$N$119</c:f>
              <c:strCache>
                <c:ptCount val="1"/>
                <c:pt idx="0">
                  <c:v>HCT116-PLKO-BFA-24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19</c:f>
                <c:numCache>
                  <c:formatCode>General</c:formatCode>
                  <c:ptCount val="1"/>
                  <c:pt idx="0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7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19</c:f>
              <c:numCache>
                <c:formatCode>0.00</c:formatCode>
                <c:ptCount val="1"/>
                <c:pt idx="0">
                  <c:v>0.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CB-417B-8B20-5E07A7AED977}"/>
            </c:ext>
          </c:extLst>
        </c:ser>
        <c:ser>
          <c:idx val="2"/>
          <c:order val="2"/>
          <c:tx>
            <c:strRef>
              <c:f>'[Chart in Microsoft PowerPoint]290717-PLKO-MIRNAS'!$N$120</c:f>
              <c:strCache>
                <c:ptCount val="1"/>
                <c:pt idx="0">
                  <c:v>HCT116-PERK-KD-Un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20</c:f>
                <c:numCache>
                  <c:formatCode>General</c:formatCode>
                  <c:ptCount val="1"/>
                  <c:pt idx="0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7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20</c:f>
              <c:numCache>
                <c:formatCode>0.00</c:formatCode>
                <c:ptCount val="1"/>
                <c:pt idx="0">
                  <c:v>1.12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CB-417B-8B20-5E07A7AED977}"/>
            </c:ext>
          </c:extLst>
        </c:ser>
        <c:ser>
          <c:idx val="3"/>
          <c:order val="3"/>
          <c:tx>
            <c:strRef>
              <c:f>'[Chart in Microsoft PowerPoint]290717-PLKO-MIRNAS'!$N$121</c:f>
              <c:strCache>
                <c:ptCount val="1"/>
                <c:pt idx="0">
                  <c:v>HCT116-PERK-KD-BFA-24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21</c:f>
                <c:numCache>
                  <c:formatCode>General</c:formatCode>
                  <c:ptCount val="1"/>
                  <c:pt idx="0">
                    <c:v>0.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7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21</c:f>
              <c:numCache>
                <c:formatCode>0.00</c:formatCode>
                <c:ptCount val="1"/>
                <c:pt idx="0">
                  <c:v>0.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4CB-417B-8B20-5E07A7AED9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1958320"/>
        <c:axId val="361959104"/>
      </c:barChart>
      <c:catAx>
        <c:axId val="36195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1959104"/>
        <c:crosses val="autoZero"/>
        <c:auto val="1"/>
        <c:lblAlgn val="ctr"/>
        <c:lblOffset val="100"/>
        <c:noMultiLvlLbl val="0"/>
      </c:catAx>
      <c:valAx>
        <c:axId val="361959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3.9197530864197534E-2"/>
              <c:y val="5.384259259259259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1958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2664609053497939E-2"/>
          <c:y val="0.71189537037037032"/>
          <c:w val="0.90991872427983544"/>
          <c:h val="0.288104629629629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973919753086418"/>
          <c:y val="3.2293981481481479E-2"/>
          <c:w val="0.56879989711934142"/>
          <c:h val="0.551979629629629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90717-PLKO-MIRNAS'!$N$111</c:f>
              <c:strCache>
                <c:ptCount val="1"/>
                <c:pt idx="0">
                  <c:v>HCT116-PLKO-U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11</c:f>
                <c:numCache>
                  <c:formatCode>General</c:formatCode>
                  <c:ptCount val="1"/>
                  <c:pt idx="0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0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11</c:f>
              <c:numCache>
                <c:formatCode>0.00</c:formatCode>
                <c:ptCount val="1"/>
                <c:pt idx="0">
                  <c:v>1.00045265220498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1B-47CA-B52B-7251F9D8F2F7}"/>
            </c:ext>
          </c:extLst>
        </c:ser>
        <c:ser>
          <c:idx val="1"/>
          <c:order val="1"/>
          <c:tx>
            <c:strRef>
              <c:f>'[Chart in Microsoft PowerPoint]290717-PLKO-MIRNAS'!$N$112</c:f>
              <c:strCache>
                <c:ptCount val="1"/>
                <c:pt idx="0">
                  <c:v>HCT116-PLKO-BFA-24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12</c:f>
                <c:numCache>
                  <c:formatCode>General</c:formatCode>
                  <c:ptCount val="1"/>
                  <c:pt idx="0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0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12</c:f>
              <c:numCache>
                <c:formatCode>0.00</c:formatCode>
                <c:ptCount val="1"/>
                <c:pt idx="0">
                  <c:v>0.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A1B-47CA-B52B-7251F9D8F2F7}"/>
            </c:ext>
          </c:extLst>
        </c:ser>
        <c:ser>
          <c:idx val="2"/>
          <c:order val="2"/>
          <c:tx>
            <c:strRef>
              <c:f>'[Chart in Microsoft PowerPoint]290717-PLKO-MIRNAS'!$N$113</c:f>
              <c:strCache>
                <c:ptCount val="1"/>
                <c:pt idx="0">
                  <c:v>HCT116-XBP1-KD-Un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13</c:f>
                <c:numCache>
                  <c:formatCode>General</c:formatCode>
                  <c:ptCount val="1"/>
                  <c:pt idx="0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0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13</c:f>
              <c:numCache>
                <c:formatCode>0.00</c:formatCode>
                <c:ptCount val="1"/>
                <c:pt idx="0">
                  <c:v>1.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A1B-47CA-B52B-7251F9D8F2F7}"/>
            </c:ext>
          </c:extLst>
        </c:ser>
        <c:ser>
          <c:idx val="3"/>
          <c:order val="3"/>
          <c:tx>
            <c:strRef>
              <c:f>'[Chart in Microsoft PowerPoint]290717-PLKO-MIRNAS'!$N$114</c:f>
              <c:strCache>
                <c:ptCount val="1"/>
                <c:pt idx="0">
                  <c:v>HCT116-XBP1-KD-BFA-24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290717-PLKO-MIRNAS'!$P$114</c:f>
                <c:numCache>
                  <c:formatCode>General</c:formatCode>
                  <c:ptCount val="1"/>
                  <c:pt idx="0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90717-PLKO-MIRNAS'!$O$110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90717-PLKO-MIRNAS'!$O$114</c:f>
              <c:numCache>
                <c:formatCode>0.00</c:formatCode>
                <c:ptCount val="1"/>
                <c:pt idx="0">
                  <c:v>1.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A1B-47CA-B52B-7251F9D8F2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3058104"/>
        <c:axId val="274154032"/>
      </c:barChart>
      <c:catAx>
        <c:axId val="363058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4154032"/>
        <c:crosses val="autoZero"/>
        <c:auto val="1"/>
        <c:lblAlgn val="ctr"/>
        <c:lblOffset val="100"/>
        <c:noMultiLvlLbl val="0"/>
      </c:catAx>
      <c:valAx>
        <c:axId val="274154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3.2664609053497939E-2"/>
              <c:y val="5.678240740740740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30581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8153292181069971E-2"/>
          <c:y val="0.71189537037037032"/>
          <c:w val="0.91756172839506156"/>
          <c:h val="0.282224999999999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483452380952377"/>
          <c:y val="7.0555555555555552E-2"/>
          <c:w val="0.70796507936507924"/>
          <c:h val="0.6459505050505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20317-MCF7-MIR-378-1'!$B$43</c:f>
              <c:strCache>
                <c:ptCount val="1"/>
                <c:pt idx="0">
                  <c:v>MCF7-miR-CTR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20317-MCF7-MIR-378-1'!$C$48</c:f>
                <c:numCache>
                  <c:formatCode>General</c:formatCode>
                  <c:ptCount val="1"/>
                  <c:pt idx="0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0317-MCF7-MIR-378-1'!$C$42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220317-MCF7-MIR-378-1'!$C$43</c:f>
              <c:numCache>
                <c:formatCode>0.00</c:formatCode>
                <c:ptCount val="1"/>
                <c:pt idx="0">
                  <c:v>1.00062017726096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6D-4565-8985-D135E224C40C}"/>
            </c:ext>
          </c:extLst>
        </c:ser>
        <c:ser>
          <c:idx val="1"/>
          <c:order val="1"/>
          <c:tx>
            <c:strRef>
              <c:f>'220317-MCF7-MIR-378-1'!$B$44</c:f>
              <c:strCache>
                <c:ptCount val="1"/>
                <c:pt idx="0">
                  <c:v>MCF7-miR-378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20317-MCF7-MIR-378-1'!$C$49</c:f>
                <c:numCache>
                  <c:formatCode>General</c:formatCode>
                  <c:ptCount val="1"/>
                  <c:pt idx="0">
                    <c:v>13.907553522273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0317-MCF7-MIR-378-1'!$C$42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220317-MCF7-MIR-378-1'!$C$44</c:f>
              <c:numCache>
                <c:formatCode>0.00</c:formatCode>
                <c:ptCount val="1"/>
                <c:pt idx="0">
                  <c:v>68.8011720356413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6D-4565-8985-D135E224C4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0876488"/>
        <c:axId val="266179376"/>
      </c:barChart>
      <c:catAx>
        <c:axId val="410876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6179376"/>
        <c:crosses val="autoZero"/>
        <c:auto val="1"/>
        <c:lblAlgn val="ctr"/>
        <c:lblOffset val="100"/>
        <c:noMultiLvlLbl val="0"/>
      </c:catAx>
      <c:valAx>
        <c:axId val="2661793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3.0391823059373324E-2"/>
              <c:y val="6.437878787878788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08764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397722222222222"/>
          <c:y val="0.85327575757575758"/>
          <c:w val="0.53716150793650796"/>
          <c:h val="0.1467242424242424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557226955901795"/>
          <c:y val="7.0555555555555552E-2"/>
          <c:w val="0.73206022924698744"/>
          <c:h val="0.598372097307597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31117-mda-231.mir-clones'!$K$34</c:f>
              <c:strCache>
                <c:ptCount val="1"/>
                <c:pt idx="0">
                  <c:v>MDA-MB-231-miR-CTR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31117-mda-231.mir-clones'!$L$33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31117-mda-231.mir-clones'!$L$34</c:f>
              <c:numCache>
                <c:formatCode>0.00</c:formatCode>
                <c:ptCount val="1"/>
                <c:pt idx="0">
                  <c:v>0.99986524561013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78-4D7E-B996-B52919C2512A}"/>
            </c:ext>
          </c:extLst>
        </c:ser>
        <c:ser>
          <c:idx val="1"/>
          <c:order val="1"/>
          <c:tx>
            <c:strRef>
              <c:f>'[Chart in Microsoft PowerPoint]231117-mda-231.mir-clones'!$K$35</c:f>
              <c:strCache>
                <c:ptCount val="1"/>
                <c:pt idx="0">
                  <c:v>MDA-MB-231-miR-378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E78-4D7E-B996-B52919C2512A}"/>
              </c:ext>
            </c:extLst>
          </c:dPt>
          <c:errBars>
            <c:errBarType val="plus"/>
            <c:errValType val="cust"/>
            <c:noEndCap val="0"/>
            <c:plus>
              <c:numRef>
                <c:f>'[Chart in Microsoft PowerPoint]231117-mda-231.mir-clones'!$D$37</c:f>
                <c:numCache>
                  <c:formatCode>General</c:formatCode>
                  <c:ptCount val="1"/>
                  <c:pt idx="0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231117-mda-231.mir-clones'!$L$33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[Chart in Microsoft PowerPoint]231117-mda-231.mir-clones'!$L$35</c:f>
              <c:numCache>
                <c:formatCode>0.00</c:formatCode>
                <c:ptCount val="1"/>
                <c:pt idx="0">
                  <c:v>80.7851140973692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E78-4D7E-B996-B52919C251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2015504"/>
        <c:axId val="362015896"/>
      </c:barChart>
      <c:catAx>
        <c:axId val="36201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2015896"/>
        <c:crosses val="autoZero"/>
        <c:auto val="1"/>
        <c:lblAlgn val="ctr"/>
        <c:lblOffset val="100"/>
        <c:noMultiLvlLbl val="0"/>
      </c:catAx>
      <c:valAx>
        <c:axId val="362015896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1.0988212330331619E-2"/>
              <c:y val="8.013105603939994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201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5312047116918857"/>
          <c:y val="0.79521738041915824"/>
          <c:w val="0.5867140470811355"/>
          <c:h val="0.168372727272727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080110586823625"/>
          <c:y val="6.453400823844456E-2"/>
          <c:w val="0.69369395664088473"/>
          <c:h val="0.611785584239233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111160HCT116 Over'!$S$15</c:f>
              <c:strCache>
                <c:ptCount val="1"/>
                <c:pt idx="0">
                  <c:v>HCT116-miR-CTRL</c:v>
                </c:pt>
              </c:strCache>
            </c:strRef>
          </c:tx>
          <c:spPr>
            <a:solidFill>
              <a:srgbClr val="4F81BD"/>
            </a:solidFill>
            <a:ln w="25400">
              <a:noFill/>
            </a:ln>
          </c:spPr>
          <c:invertIfNegative val="0"/>
          <c:errBars>
            <c:errBarType val="plus"/>
            <c:errValType val="percentage"/>
            <c:noEndCap val="0"/>
            <c:val val="5"/>
          </c:errBars>
          <c:cat>
            <c:strRef>
              <c:f>'2111160HCT116 Over'!$T$14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2111160HCT116 Over'!$T$15</c:f>
              <c:numCache>
                <c:formatCode>0.00</c:formatCode>
                <c:ptCount val="1"/>
                <c:pt idx="0">
                  <c:v>1.000434002641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95-4C70-A887-5A6D2996F641}"/>
            </c:ext>
          </c:extLst>
        </c:ser>
        <c:ser>
          <c:idx val="1"/>
          <c:order val="1"/>
          <c:tx>
            <c:strRef>
              <c:f>'2111160HCT116 Over'!$S$16</c:f>
              <c:strCache>
                <c:ptCount val="1"/>
                <c:pt idx="0">
                  <c:v>HCT116-miR-378</c:v>
                </c:pt>
              </c:strCache>
            </c:strRef>
          </c:tx>
          <c:spPr>
            <a:solidFill>
              <a:srgbClr val="C00000"/>
            </a:solidFill>
            <a:ln w="25400">
              <a:noFill/>
            </a:ln>
          </c:spPr>
          <c:invertIfNegative val="0"/>
          <c:errBars>
            <c:errBarType val="plus"/>
            <c:errValType val="percentage"/>
            <c:noEndCap val="0"/>
            <c:val val="5"/>
          </c:errBars>
          <c:cat>
            <c:strRef>
              <c:f>'2111160HCT116 Over'!$T$14</c:f>
              <c:strCache>
                <c:ptCount val="1"/>
                <c:pt idx="0">
                  <c:v>miR-378</c:v>
                </c:pt>
              </c:strCache>
            </c:strRef>
          </c:cat>
          <c:val>
            <c:numRef>
              <c:f>'2111160HCT116 Over'!$T$16</c:f>
              <c:numCache>
                <c:formatCode>0.00</c:formatCode>
                <c:ptCount val="1"/>
                <c:pt idx="0">
                  <c:v>93.9812108718193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95-4C70-A887-5A6D2996F6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2016680"/>
        <c:axId val="362017072"/>
      </c:barChart>
      <c:catAx>
        <c:axId val="362016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b="1"/>
            </a:pPr>
            <a:endParaRPr lang="en-US"/>
          </a:p>
        </c:txPr>
        <c:crossAx val="362017072"/>
        <c:crosses val="autoZero"/>
        <c:auto val="1"/>
        <c:lblAlgn val="ctr"/>
        <c:lblOffset val="100"/>
        <c:noMultiLvlLbl val="0"/>
      </c:catAx>
      <c:valAx>
        <c:axId val="3620170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expression </a:t>
                </a:r>
              </a:p>
            </c:rich>
          </c:tx>
          <c:layout>
            <c:manualLayout>
              <c:xMode val="edge"/>
              <c:yMode val="edge"/>
              <c:x val="7.7951121958562278E-3"/>
              <c:y val="7.673948005249541E-2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62016680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27137633571694963"/>
          <c:y val="0.79133588350869755"/>
          <c:w val="0.62199250863452837"/>
          <c:h val="0.17017916341098915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0">
          <a:solidFill>
            <a:schemeClr val="tx1"/>
          </a:solidFill>
        </a:defRPr>
      </a:pPr>
      <a:endParaRPr lang="en-US"/>
    </a:p>
  </c:tx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5614</cdr:x>
      <cdr:y>0.08876</cdr:y>
    </cdr:from>
    <cdr:to>
      <cdr:x>0.74438</cdr:x>
      <cdr:y>0.2009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1653467" y="175751"/>
          <a:ext cx="222365" cy="22215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/>
            <a:t>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562</cdr:x>
      <cdr:y>0.07445</cdr:y>
    </cdr:from>
    <cdr:to>
      <cdr:x>0.74543</cdr:x>
      <cdr:y>0.22791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1525777" y="157025"/>
          <a:ext cx="207476" cy="32366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/>
            <a:t>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49748</cdr:x>
      <cdr:y>0.16954</cdr:y>
    </cdr:from>
    <cdr:to>
      <cdr:x>0.49748</cdr:x>
      <cdr:y>0.47494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DFB4DDC3-124C-6A46-2F07-5199E84606AC}"/>
            </a:ext>
          </a:extLst>
        </cdr:cNvPr>
        <cdr:cNvCxnSpPr/>
      </cdr:nvCxnSpPr>
      <cdr:spPr>
        <a:xfrm xmlns:a="http://schemas.openxmlformats.org/drawingml/2006/main" flipV="1">
          <a:off x="1074549" y="372311"/>
          <a:ext cx="0" cy="670661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51162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A5041-2869-4A0B-8777-B2AC57937548}" type="datetimeFigureOut">
              <a:rPr lang="en-IE" smtClean="0"/>
              <a:t>11/10/2023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3863" y="1243013"/>
            <a:ext cx="5961062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6712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51162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98BA2E-E22D-4986-9768-4EEBBF803DB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75032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AE21E-66F2-4905-88A6-FB33BD6350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2BC201-1DD3-49D7-BD12-F68194A0AE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3" indent="0" algn="ctr">
              <a:buNone/>
              <a:defRPr sz="1801"/>
            </a:lvl3pPr>
            <a:lvl4pPr marL="1371634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9" indent="0" algn="ctr">
              <a:buNone/>
              <a:defRPr sz="1600"/>
            </a:lvl7pPr>
            <a:lvl8pPr marL="3200480" indent="0" algn="ctr">
              <a:buNone/>
              <a:defRPr sz="1600"/>
            </a:lvl8pPr>
            <a:lvl9pPr marL="3657691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F84679-915F-411B-B476-E6750F62E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C2F12-AEF7-4248-A54D-AAC78F8A9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C7C2E9-8F93-4E40-9811-598D35D7C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62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35C338-A6E2-41FA-9FBE-94F75290C6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B85361-C09C-43C6-97A2-627B0ABF28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B45133-2B54-4C82-A598-A9A21C6F8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9A13D8-1340-409F-A311-D92A13554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65107-DF31-4EB2-8F3F-B9AC19DA9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34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F2B788-D8AE-4E4D-849C-1DB45B5358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1B0B95-434B-43BF-82CE-68A9CDC113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94ABC7-5E7F-4EB5-8DB4-A3506C4C0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1A490A-B39C-4428-A5F5-9AB070F9F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5EE67A-5EE8-44CE-8A78-2BDA110FC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426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8214F5-8478-4ADB-8ABD-AB5D96A2EB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F2E614-8929-40EF-B162-0E1BA38E47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943398-21E9-4418-9F6E-78FE51977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AAD039-6670-4EDE-86FF-EB247790D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020752-7027-4692-AF20-C9E5F6510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76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67A7C8-FCFB-45CA-8FB1-DFBEC3D739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6EE053-55F4-432C-B2CE-ED8A8A5417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3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4F1166-1DCA-4D5C-A7BE-A013E7BAE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EF7CDE-275D-45E2-AC50-36552AEF7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BD96CB-B762-4DD2-A990-B585BEC1F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83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CCFBC4-8610-4E02-BDA7-B2795650B5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63602C-774C-494F-91C8-15F4F1E94E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94CF2F-0409-4CFA-B97E-BB0CFF2F6C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83C3CC-2DCA-48E9-B4D1-E7C96EBCE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93CCDD-E35E-41F6-9F35-A56FEF38F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BC89FE-FA60-4E0F-8A0D-AEF78E578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543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9224A-5D0B-475E-BEB9-8B25AEF4CA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E3405D-DE13-4FD2-9065-EA57E81EB5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53BE7B-4E9B-4B5E-93BD-43A2FE8CBD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1603DC-F68F-4586-9180-604BD7DC3B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CC5FEA-AA5E-4992-B6FA-881F8D4B13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FBC889-BFF8-4080-9401-A228252D8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4A162B-7979-4E76-AC4C-CC0246179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15EE0B-F555-467E-A9BB-2D462904F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088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A07F76-75B4-4CD5-9187-0074A9015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80A215-B42D-4FCF-8178-38D1173D8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690BC9-4EBB-49C2-B4A9-2047E2C0E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C1A9F4-E49E-4B9C-BE12-390BAFCCE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956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503B22-8214-4AC6-9C9C-802CB8218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1C0457-BA55-4E79-A515-497BEEE1E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DC581C-6659-4785-9A9F-20EBE16F9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077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6B966-AC7E-4329-96CD-22EAFB3166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50C7AB-BED6-4F36-97CB-76ACCE8712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699EEE-28AE-4107-9B6C-A44CF1E934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9" indent="0">
              <a:buNone/>
              <a:defRPr sz="1001"/>
            </a:lvl7pPr>
            <a:lvl8pPr marL="3200480" indent="0">
              <a:buNone/>
              <a:defRPr sz="1001"/>
            </a:lvl8pPr>
            <a:lvl9pPr marL="3657691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136F5-0736-4144-AFC7-FC4B5E275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1E3D54-F5A6-48A1-832D-A39F4E271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13433C-09EC-4C0D-98EA-6E9C9B37B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048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36767-1254-4D98-9B7E-12B9D64FC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AF09D5-8F28-4C05-8668-4D1FEB6EEC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3" indent="0">
              <a:buNone/>
              <a:defRPr sz="2400"/>
            </a:lvl3pPr>
            <a:lvl4pPr marL="1371634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9" indent="0">
              <a:buNone/>
              <a:defRPr sz="2000"/>
            </a:lvl7pPr>
            <a:lvl8pPr marL="3200480" indent="0">
              <a:buNone/>
              <a:defRPr sz="2000"/>
            </a:lvl8pPr>
            <a:lvl9pPr marL="3657691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D0E5A2-33BF-457D-A2BC-62D0BE2ED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9" indent="0">
              <a:buNone/>
              <a:defRPr sz="1001"/>
            </a:lvl7pPr>
            <a:lvl8pPr marL="3200480" indent="0">
              <a:buNone/>
              <a:defRPr sz="1001"/>
            </a:lvl8pPr>
            <a:lvl9pPr marL="3657691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14D049-A9FC-413F-B1A7-785E158802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B3C7E0-142F-4A6B-B31B-2826A4A20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E1F0A4-EECE-43A6-A515-013810D2C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38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1A4C4E-3EC2-41DE-8669-317A60B7E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1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1503BF-BAE1-4CC2-8514-A2E16235C3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492B3F-F1BC-4E62-A08A-41E677AC9B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5F2B1-7795-4F4E-A362-77943BEF59E1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6CEECA-7584-4493-A099-90014F537D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1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B09E1-D4EB-4E70-982A-7A8B45998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9BF81-31E4-445D-9A80-F4ED84E6C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193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3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1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2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3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3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4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0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1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microsoft.com/office/2007/relationships/hdphoto" Target="../media/hdphoto9.wdp"/><Relationship Id="rId3" Type="http://schemas.openxmlformats.org/officeDocument/2006/relationships/chart" Target="../charts/chart5.xml"/><Relationship Id="rId7" Type="http://schemas.openxmlformats.org/officeDocument/2006/relationships/image" Target="../media/image8.png"/><Relationship Id="rId12" Type="http://schemas.openxmlformats.org/officeDocument/2006/relationships/image" Target="../media/image11.png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6" Type="http://schemas.microsoft.com/office/2007/relationships/hdphoto" Target="../media/hdphoto6.wdp"/><Relationship Id="rId11" Type="http://schemas.microsoft.com/office/2007/relationships/hdphoto" Target="../media/hdphoto8.wdp"/><Relationship Id="rId5" Type="http://schemas.openxmlformats.org/officeDocument/2006/relationships/image" Target="../media/image7.png"/><Relationship Id="rId15" Type="http://schemas.microsoft.com/office/2007/relationships/hdphoto" Target="../media/hdphoto10.wdp"/><Relationship Id="rId10" Type="http://schemas.openxmlformats.org/officeDocument/2006/relationships/image" Target="../media/image10.png"/><Relationship Id="rId4" Type="http://schemas.openxmlformats.org/officeDocument/2006/relationships/chart" Target="../charts/chart6.xml"/><Relationship Id="rId9" Type="http://schemas.microsoft.com/office/2007/relationships/hdphoto" Target="../media/hdphoto7.wdp"/><Relationship Id="rId1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13" Type="http://schemas.microsoft.com/office/2007/relationships/hdphoto" Target="../media/hdphoto13.wdp"/><Relationship Id="rId18" Type="http://schemas.openxmlformats.org/officeDocument/2006/relationships/image" Target="../media/image21.png"/><Relationship Id="rId26" Type="http://schemas.openxmlformats.org/officeDocument/2006/relationships/image" Target="../media/image25.png"/><Relationship Id="rId3" Type="http://schemas.openxmlformats.org/officeDocument/2006/relationships/chart" Target="../charts/chart8.xml"/><Relationship Id="rId21" Type="http://schemas.microsoft.com/office/2007/relationships/hdphoto" Target="../media/hdphoto17.wdp"/><Relationship Id="rId34" Type="http://schemas.openxmlformats.org/officeDocument/2006/relationships/image" Target="../media/image29.png"/><Relationship Id="rId7" Type="http://schemas.microsoft.com/office/2007/relationships/hdphoto" Target="../media/hdphoto11.wdp"/><Relationship Id="rId12" Type="http://schemas.openxmlformats.org/officeDocument/2006/relationships/image" Target="../media/image18.png"/><Relationship Id="rId17" Type="http://schemas.microsoft.com/office/2007/relationships/hdphoto" Target="../media/hdphoto15.wdp"/><Relationship Id="rId25" Type="http://schemas.microsoft.com/office/2007/relationships/hdphoto" Target="../media/hdphoto19.wdp"/><Relationship Id="rId33" Type="http://schemas.microsoft.com/office/2007/relationships/hdphoto" Target="../media/hdphoto23.wdp"/><Relationship Id="rId2" Type="http://schemas.openxmlformats.org/officeDocument/2006/relationships/chart" Target="../charts/chart7.xml"/><Relationship Id="rId16" Type="http://schemas.openxmlformats.org/officeDocument/2006/relationships/image" Target="../media/image20.png"/><Relationship Id="rId20" Type="http://schemas.openxmlformats.org/officeDocument/2006/relationships/image" Target="../media/image22.png"/><Relationship Id="rId29" Type="http://schemas.microsoft.com/office/2007/relationships/hdphoto" Target="../media/hdphoto21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microsoft.com/office/2007/relationships/hdphoto" Target="../media/hdphoto12.wdp"/><Relationship Id="rId24" Type="http://schemas.openxmlformats.org/officeDocument/2006/relationships/image" Target="../media/image24.png"/><Relationship Id="rId32" Type="http://schemas.openxmlformats.org/officeDocument/2006/relationships/image" Target="../media/image28.png"/><Relationship Id="rId5" Type="http://schemas.openxmlformats.org/officeDocument/2006/relationships/chart" Target="../charts/chart10.xml"/><Relationship Id="rId15" Type="http://schemas.microsoft.com/office/2007/relationships/hdphoto" Target="../media/hdphoto14.wdp"/><Relationship Id="rId23" Type="http://schemas.microsoft.com/office/2007/relationships/hdphoto" Target="../media/hdphoto18.wdp"/><Relationship Id="rId28" Type="http://schemas.openxmlformats.org/officeDocument/2006/relationships/image" Target="../media/image26.png"/><Relationship Id="rId10" Type="http://schemas.openxmlformats.org/officeDocument/2006/relationships/image" Target="../media/image17.png"/><Relationship Id="rId19" Type="http://schemas.microsoft.com/office/2007/relationships/hdphoto" Target="../media/hdphoto16.wdp"/><Relationship Id="rId31" Type="http://schemas.microsoft.com/office/2007/relationships/hdphoto" Target="../media/hdphoto22.wdp"/><Relationship Id="rId4" Type="http://schemas.openxmlformats.org/officeDocument/2006/relationships/chart" Target="../charts/chart9.xml"/><Relationship Id="rId9" Type="http://schemas.openxmlformats.org/officeDocument/2006/relationships/image" Target="../media/image16.jpeg"/><Relationship Id="rId14" Type="http://schemas.openxmlformats.org/officeDocument/2006/relationships/image" Target="../media/image19.png"/><Relationship Id="rId22" Type="http://schemas.openxmlformats.org/officeDocument/2006/relationships/image" Target="../media/image23.png"/><Relationship Id="rId27" Type="http://schemas.microsoft.com/office/2007/relationships/hdphoto" Target="../media/hdphoto20.wdp"/><Relationship Id="rId30" Type="http://schemas.openxmlformats.org/officeDocument/2006/relationships/image" Target="../media/image27.png"/><Relationship Id="rId35" Type="http://schemas.microsoft.com/office/2007/relationships/hdphoto" Target="../media/hdphoto24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jpg"/><Relationship Id="rId5" Type="http://schemas.openxmlformats.org/officeDocument/2006/relationships/image" Target="../media/image30.jpg"/><Relationship Id="rId4" Type="http://schemas.openxmlformats.org/officeDocument/2006/relationships/chart" Target="../charts/chart1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hyperlink" Target="http://www.geneontology.org/" TargetMode="External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1230142" y="682492"/>
            <a:ext cx="9448460" cy="2169597"/>
            <a:chOff x="928138" y="707659"/>
            <a:chExt cx="9448460" cy="2169597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2606495"/>
                </p:ext>
              </p:extLst>
            </p:nvPr>
          </p:nvGraphicFramePr>
          <p:xfrm>
            <a:off x="928138" y="717256"/>
            <a:ext cx="30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91335470"/>
                </p:ext>
              </p:extLst>
            </p:nvPr>
          </p:nvGraphicFramePr>
          <p:xfrm>
            <a:off x="4138946" y="707659"/>
            <a:ext cx="30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9229137"/>
                </p:ext>
              </p:extLst>
            </p:nvPr>
          </p:nvGraphicFramePr>
          <p:xfrm>
            <a:off x="7316598" y="714219"/>
            <a:ext cx="30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B5F63909-3971-4F88-A91C-23516E45B321}"/>
              </a:ext>
            </a:extLst>
          </p:cNvPr>
          <p:cNvSpPr txBox="1"/>
          <p:nvPr/>
        </p:nvSpPr>
        <p:spPr>
          <a:xfrm>
            <a:off x="3287340" y="3173424"/>
            <a:ext cx="5583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ry figure 1. </a:t>
            </a:r>
            <a:r>
              <a:rPr lang="en-US" sz="1200" b="1" dirty="0"/>
              <a:t>Effect of three different pharmacological inducers of UPR on cell viability.</a:t>
            </a:r>
            <a:r>
              <a:rPr lang="en-US" sz="1200" dirty="0"/>
              <a:t> </a:t>
            </a:r>
            <a:r>
              <a:rPr lang="en-IE" sz="1200" dirty="0"/>
              <a:t>(A) HCT116 cells, (B) MCF7 and (C) RKO cells were either untreated or treated with (1µM) TG, (1.0 μg/ml) TM and (0.5µg/ml) BFA for 24 hours. Fold change in absorbance at 490 nm are shown, with value of untreated samples set at 1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22852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2233817" y="83015"/>
            <a:ext cx="2957359" cy="5108678"/>
            <a:chOff x="700292" y="111590"/>
            <a:chExt cx="2957359" cy="5108678"/>
          </a:xfrm>
        </p:grpSpPr>
        <p:grpSp>
          <p:nvGrpSpPr>
            <p:cNvPr id="20" name="Group 19"/>
            <p:cNvGrpSpPr/>
            <p:nvPr/>
          </p:nvGrpSpPr>
          <p:grpSpPr>
            <a:xfrm>
              <a:off x="700292" y="111590"/>
              <a:ext cx="2269821" cy="5108678"/>
              <a:chOff x="2243342" y="121115"/>
              <a:chExt cx="2269821" cy="5108678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2351453" y="1734771"/>
                <a:ext cx="2161710" cy="3495022"/>
                <a:chOff x="2303828" y="1039446"/>
                <a:chExt cx="2161710" cy="3495022"/>
              </a:xfrm>
            </p:grpSpPr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prstClr val="black"/>
                    <a:schemeClr val="accent3">
                      <a:tint val="45000"/>
                      <a:satMod val="400000"/>
                    </a:schemeClr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03828" y="4095923"/>
                  <a:ext cx="2160000" cy="438545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4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rcRect l="23671"/>
                <a:stretch/>
              </p:blipFill>
              <p:spPr>
                <a:xfrm>
                  <a:off x="2305538" y="1039446"/>
                  <a:ext cx="2160000" cy="3037747"/>
                </a:xfrm>
                <a:prstGeom prst="rect">
                  <a:avLst/>
                </a:prstGeom>
              </p:spPr>
            </p:pic>
          </p:grpSp>
          <p:sp>
            <p:nvSpPr>
              <p:cNvPr id="16" name="TextBox 15"/>
              <p:cNvSpPr txBox="1"/>
              <p:nvPr/>
            </p:nvSpPr>
            <p:spPr>
              <a:xfrm rot="16200000">
                <a:off x="2507581" y="-143124"/>
                <a:ext cx="1681999" cy="22104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LKO-Un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LKO-BFA-24h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ATF6-KD-Un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ATF6-KD-BFA-24h</a:t>
                </a:r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>
              <a:off x="2943225" y="2362200"/>
              <a:ext cx="714426" cy="1569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ATF6 (F)</a:t>
              </a:r>
            </a:p>
            <a:p>
              <a:endParaRPr lang="en-IE" sz="1200" dirty="0"/>
            </a:p>
            <a:p>
              <a:endParaRPr lang="en-IE" sz="1200" dirty="0"/>
            </a:p>
            <a:p>
              <a:endParaRPr lang="en-IE" sz="1200" dirty="0"/>
            </a:p>
            <a:p>
              <a:endParaRPr lang="en-IE" sz="1200" dirty="0"/>
            </a:p>
            <a:p>
              <a:endParaRPr lang="en-IE" sz="1200" dirty="0"/>
            </a:p>
            <a:p>
              <a:endParaRPr lang="en-IE" sz="1200" dirty="0"/>
            </a:p>
            <a:p>
              <a:r>
                <a:rPr lang="en-IE" sz="1200" dirty="0"/>
                <a:t>ATF6 (N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914650" y="4848225"/>
              <a:ext cx="5690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ACTIN</a:t>
              </a: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5156694" y="112683"/>
            <a:ext cx="2931682" cy="2667048"/>
            <a:chOff x="5156694" y="112683"/>
            <a:chExt cx="2931682" cy="2667048"/>
          </a:xfrm>
        </p:grpSpPr>
        <p:grpSp>
          <p:nvGrpSpPr>
            <p:cNvPr id="21" name="Group 20"/>
            <p:cNvGrpSpPr/>
            <p:nvPr/>
          </p:nvGrpSpPr>
          <p:grpSpPr>
            <a:xfrm>
              <a:off x="5156694" y="112683"/>
              <a:ext cx="2379921" cy="2667048"/>
              <a:chOff x="5156694" y="112683"/>
              <a:chExt cx="2379921" cy="2667048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376615" y="2446691"/>
                <a:ext cx="2160000" cy="333040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 rot="16200000">
                <a:off x="5461424" y="-192047"/>
                <a:ext cx="1698863" cy="23083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LKO-Un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LKO-BFA-24h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ERK-KD-Un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ERK-KD-BFA-24h</a:t>
                </a:r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7458075" y="1905000"/>
              <a:ext cx="63030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P-PERK</a:t>
              </a:r>
            </a:p>
            <a:p>
              <a:r>
                <a:rPr lang="en-IE" sz="1200" dirty="0"/>
                <a:t>PERK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467600" y="2419350"/>
              <a:ext cx="5690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ACTIN</a:t>
              </a: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8357094" y="82505"/>
            <a:ext cx="2878690" cy="2648605"/>
            <a:chOff x="8357094" y="82505"/>
            <a:chExt cx="2878690" cy="2648605"/>
          </a:xfrm>
        </p:grpSpPr>
        <p:grpSp>
          <p:nvGrpSpPr>
            <p:cNvPr id="22" name="Group 21"/>
            <p:cNvGrpSpPr/>
            <p:nvPr/>
          </p:nvGrpSpPr>
          <p:grpSpPr>
            <a:xfrm>
              <a:off x="8357094" y="82505"/>
              <a:ext cx="2343318" cy="2648605"/>
              <a:chOff x="7833219" y="111080"/>
              <a:chExt cx="2343318" cy="2648605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8011447" y="1725109"/>
                <a:ext cx="2165090" cy="1034576"/>
                <a:chOff x="8554372" y="2601409"/>
                <a:chExt cx="2165090" cy="1034576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559462" y="3115689"/>
                  <a:ext cx="2160000" cy="520296"/>
                </a:xfrm>
                <a:prstGeom prst="rect">
                  <a:avLst/>
                </a:prstGeom>
              </p:spPr>
            </p:pic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554372" y="2601409"/>
                  <a:ext cx="2160000" cy="484365"/>
                </a:xfrm>
                <a:prstGeom prst="rect">
                  <a:avLst/>
                </a:prstGeom>
              </p:spPr>
            </p:pic>
          </p:grpSp>
          <p:sp>
            <p:nvSpPr>
              <p:cNvPr id="19" name="TextBox 18"/>
              <p:cNvSpPr txBox="1"/>
              <p:nvPr/>
            </p:nvSpPr>
            <p:spPr>
              <a:xfrm rot="16200000">
                <a:off x="8136346" y="-192047"/>
                <a:ext cx="1702069" cy="23083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LKO-Un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PLKO-BFA-24h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XBP1-KD-Un</a:t>
                </a:r>
              </a:p>
              <a:p>
                <a:pPr>
                  <a:lnSpc>
                    <a:spcPct val="300000"/>
                  </a:lnSpc>
                </a:pPr>
                <a:r>
                  <a:rPr lang="en-IE" sz="1200" dirty="0"/>
                  <a:t>MCF7-XBP1-KD-BFA-24h</a:t>
                </a:r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>
              <a:off x="10668000" y="1771650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XBP1s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0639425" y="2324100"/>
              <a:ext cx="5690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ACTIN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B5F63909-3971-4F88-A91C-23516E45B321}"/>
              </a:ext>
            </a:extLst>
          </p:cNvPr>
          <p:cNvSpPr txBox="1"/>
          <p:nvPr/>
        </p:nvSpPr>
        <p:spPr>
          <a:xfrm>
            <a:off x="5291273" y="3288591"/>
            <a:ext cx="55839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ry figure 2. </a:t>
            </a:r>
            <a:r>
              <a:rPr lang="en-US" sz="1200" b="1" dirty="0"/>
              <a:t>knockdown of the expression of ATF6, PERK and XBP1 in sub-clones of MCF7 cells expressing corresponding shRNA.</a:t>
            </a:r>
            <a:r>
              <a:rPr lang="en-US" sz="1200" dirty="0"/>
              <a:t> MCF7-control (PKLO), MCF7-XBP1 knockdown (XBP1-KD), MCF7 PERK knockdown (PERK-KD) and MCF7-ATF6 knockdown (ATF6-KD) cells were treated with (1.0 </a:t>
            </a:r>
            <a:r>
              <a:rPr lang="en-US" sz="1200" dirty="0">
                <a:sym typeface="Symbol" panose="05050102010706020507" pitchFamily="18" charset="2"/>
              </a:rPr>
              <a:t></a:t>
            </a:r>
            <a:r>
              <a:rPr lang="en-US" sz="1200" dirty="0"/>
              <a:t>g/ml) Brefeldin A (BFA) for 18 h. </a:t>
            </a:r>
            <a:r>
              <a:rPr lang="en-IE" sz="1200" dirty="0"/>
              <a:t>Western blotting of total protein was performed using the indicated antibodies.</a:t>
            </a:r>
            <a:endParaRPr lang="en-US" sz="1200" dirty="0"/>
          </a:p>
        </p:txBody>
      </p:sp>
      <p:pic>
        <p:nvPicPr>
          <p:cNvPr id="34" name="Picture 33"/>
          <p:cNvPicPr>
            <a:picLocks/>
          </p:cNvPicPr>
          <p:nvPr/>
        </p:nvPicPr>
        <p:blipFill rotWithShape="1">
          <a:blip r:embed="rId12">
            <a:grayscl/>
          </a:blip>
          <a:srcRect l="18029" t="25637" r="66591" b="67574"/>
          <a:stretch/>
        </p:blipFill>
        <p:spPr>
          <a:xfrm>
            <a:off x="5362832" y="1781324"/>
            <a:ext cx="2160000" cy="61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1932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85">
            <a:extLst>
              <a:ext uri="{FF2B5EF4-FFF2-40B4-BE49-F238E27FC236}">
                <a16:creationId xmlns:a16="http://schemas.microsoft.com/office/drawing/2014/main" id="{B5F63909-3971-4F88-A91C-23516E45B321}"/>
              </a:ext>
            </a:extLst>
          </p:cNvPr>
          <p:cNvSpPr txBox="1"/>
          <p:nvPr/>
        </p:nvSpPr>
        <p:spPr>
          <a:xfrm>
            <a:off x="6735669" y="1121191"/>
            <a:ext cx="2197932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ry figure 3. </a:t>
            </a:r>
            <a:r>
              <a:rPr lang="en-US" sz="1200" b="1" dirty="0"/>
              <a:t>XBP1 is required for downregulation of miR-378 and PPARGC1b during UPR in HCT116 cells . </a:t>
            </a:r>
            <a:r>
              <a:rPr lang="en-US" sz="1200" dirty="0"/>
              <a:t>(</a:t>
            </a:r>
            <a:r>
              <a:rPr lang="en-US" sz="1200" b="1" dirty="0"/>
              <a:t>A)</a:t>
            </a:r>
            <a:r>
              <a:rPr lang="en-US" sz="1200" dirty="0"/>
              <a:t> HCT116-PKLO, HCT116-XBP1-KD, HCT116-PERK-KD and HCT116-ATF6-KD were treated with (0.5 </a:t>
            </a:r>
            <a:r>
              <a:rPr lang="en-US" sz="1200" dirty="0">
                <a:sym typeface="Symbol" panose="05050102010706020507" pitchFamily="18" charset="2"/>
              </a:rPr>
              <a:t></a:t>
            </a:r>
            <a:r>
              <a:rPr lang="en-US" sz="1200" dirty="0"/>
              <a:t>g/ml) Brefeldin A (BFA) for 24 h. </a:t>
            </a:r>
            <a:r>
              <a:rPr lang="en-IE" sz="1200" dirty="0"/>
              <a:t>Western blotting of total protein was performed using the indicated antibodies. </a:t>
            </a:r>
            <a:r>
              <a:rPr lang="en-US" sz="1200" dirty="0"/>
              <a:t>(</a:t>
            </a:r>
            <a:r>
              <a:rPr lang="en-US" sz="1200" b="1" dirty="0"/>
              <a:t>B</a:t>
            </a:r>
            <a:r>
              <a:rPr lang="en-US" sz="1200" dirty="0"/>
              <a:t>) HCT116-PKLO, HCT116-XBP1-KD, HCT116-PERK-KD and HCT116-ATF6-KD cells were treated as in A, </a:t>
            </a:r>
            <a:r>
              <a:rPr lang="en-IE" sz="1200" dirty="0"/>
              <a:t>expression level of miR-378 was quantified by real-time RT-PCR, normalizing against </a:t>
            </a:r>
            <a:r>
              <a:rPr lang="en-US" sz="1200" dirty="0"/>
              <a:t>RNU6b.</a:t>
            </a:r>
            <a:r>
              <a:rPr lang="en-IE" sz="1200" dirty="0"/>
              <a:t> </a:t>
            </a:r>
            <a:r>
              <a:rPr lang="en-US" sz="1200" dirty="0"/>
              <a:t>*P &lt; 0.05, two-tailed unpaired t-test. N.S, not significant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81741" y="918243"/>
            <a:ext cx="293670" cy="2677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A</a:t>
            </a:r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endParaRPr lang="en-IE" sz="1400" b="1" dirty="0"/>
          </a:p>
          <a:p>
            <a:r>
              <a:rPr lang="en-IE" sz="1400" b="1" dirty="0"/>
              <a:t>B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00C000B5-F57B-4100-A484-058AC83BC062}"/>
              </a:ext>
            </a:extLst>
          </p:cNvPr>
          <p:cNvGrpSpPr/>
          <p:nvPr/>
        </p:nvGrpSpPr>
        <p:grpSpPr>
          <a:xfrm>
            <a:off x="677160" y="3366317"/>
            <a:ext cx="1944000" cy="2160000"/>
            <a:chOff x="2620069" y="4557978"/>
            <a:chExt cx="1944000" cy="2160000"/>
          </a:xfrm>
        </p:grpSpPr>
        <p:graphicFrame>
          <p:nvGraphicFramePr>
            <p:cNvPr id="111" name="Chart 110">
              <a:extLst>
                <a:ext uri="{FF2B5EF4-FFF2-40B4-BE49-F238E27FC236}">
                  <a16:creationId xmlns:a16="http://schemas.microsoft.com/office/drawing/2014/main" id="{45A7965C-BF26-45A2-8C3E-DE740DA18EF0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2620069" y="4557978"/>
            <a:ext cx="1944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5E0334A8-C504-4918-AEAB-62413F64E07A}"/>
                </a:ext>
              </a:extLst>
            </p:cNvPr>
            <p:cNvCxnSpPr/>
            <p:nvPr/>
          </p:nvCxnSpPr>
          <p:spPr>
            <a:xfrm flipV="1">
              <a:off x="4148492" y="5048250"/>
              <a:ext cx="0" cy="158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D28D823A-2E24-4D3A-8C9A-0FF28526DC5E}"/>
                </a:ext>
              </a:extLst>
            </p:cNvPr>
            <p:cNvCxnSpPr/>
            <p:nvPr/>
          </p:nvCxnSpPr>
          <p:spPr>
            <a:xfrm flipH="1">
              <a:off x="3805398" y="5048250"/>
              <a:ext cx="3430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2A482A8B-5406-4612-9DD7-74A2A51E2A0F}"/>
                </a:ext>
              </a:extLst>
            </p:cNvPr>
            <p:cNvCxnSpPr/>
            <p:nvPr/>
          </p:nvCxnSpPr>
          <p:spPr>
            <a:xfrm>
              <a:off x="3805398" y="5048250"/>
              <a:ext cx="0" cy="266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70C7825C-6BE0-4744-9F46-4F196531FFB9}"/>
              </a:ext>
            </a:extLst>
          </p:cNvPr>
          <p:cNvGrpSpPr/>
          <p:nvPr/>
        </p:nvGrpSpPr>
        <p:grpSpPr>
          <a:xfrm>
            <a:off x="2627291" y="3365756"/>
            <a:ext cx="1944000" cy="2160000"/>
            <a:chOff x="4554944" y="4552004"/>
            <a:chExt cx="1944000" cy="2160000"/>
          </a:xfrm>
        </p:grpSpPr>
        <p:graphicFrame>
          <p:nvGraphicFramePr>
            <p:cNvPr id="97" name="Chart 96">
              <a:extLst>
                <a:ext uri="{FF2B5EF4-FFF2-40B4-BE49-F238E27FC236}">
                  <a16:creationId xmlns:a16="http://schemas.microsoft.com/office/drawing/2014/main" id="{658B9C11-4A6D-41A3-9BCA-DEA6C20B7FE4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4554944" y="4552004"/>
            <a:ext cx="1944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718279E3-23E1-4667-9F5A-8C28808801D8}"/>
                </a:ext>
              </a:extLst>
            </p:cNvPr>
            <p:cNvCxnSpPr/>
            <p:nvPr/>
          </p:nvCxnSpPr>
          <p:spPr>
            <a:xfrm flipV="1">
              <a:off x="5664200" y="5048250"/>
              <a:ext cx="0" cy="266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8F670715-8E2A-4B0E-A1A0-3F9AC4A46944}"/>
                </a:ext>
              </a:extLst>
            </p:cNvPr>
            <p:cNvCxnSpPr/>
            <p:nvPr/>
          </p:nvCxnSpPr>
          <p:spPr>
            <a:xfrm>
              <a:off x="5664200" y="5048250"/>
              <a:ext cx="44754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CC8C50A7-A057-4758-A00C-590634ABE2B6}"/>
                </a:ext>
              </a:extLst>
            </p:cNvPr>
            <p:cNvCxnSpPr/>
            <p:nvPr/>
          </p:nvCxnSpPr>
          <p:spPr>
            <a:xfrm>
              <a:off x="6111745" y="5048250"/>
              <a:ext cx="0" cy="266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97226641-4D4E-4347-BBF0-E425688F8EE9}"/>
              </a:ext>
            </a:extLst>
          </p:cNvPr>
          <p:cNvGrpSpPr/>
          <p:nvPr/>
        </p:nvGrpSpPr>
        <p:grpSpPr>
          <a:xfrm>
            <a:off x="4793023" y="3264540"/>
            <a:ext cx="1944000" cy="2228387"/>
            <a:chOff x="6558671" y="4489077"/>
            <a:chExt cx="1944000" cy="2228387"/>
          </a:xfrm>
        </p:grpSpPr>
        <p:graphicFrame>
          <p:nvGraphicFramePr>
            <p:cNvPr id="120" name="Chart 119">
              <a:extLst>
                <a:ext uri="{FF2B5EF4-FFF2-40B4-BE49-F238E27FC236}">
                  <a16:creationId xmlns:a16="http://schemas.microsoft.com/office/drawing/2014/main" id="{858B3C9B-D4CC-45E0-9999-FED3247652AC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6558671" y="4557464"/>
            <a:ext cx="1944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6D23E496-543D-4A78-85FE-9960B41D71B4}"/>
                </a:ext>
              </a:extLst>
            </p:cNvPr>
            <p:cNvCxnSpPr/>
            <p:nvPr/>
          </p:nvCxnSpPr>
          <p:spPr>
            <a:xfrm flipV="1">
              <a:off x="8070850" y="4711700"/>
              <a:ext cx="0" cy="114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6F631872-24F1-4E65-9E4D-787B1CB714D1}"/>
                </a:ext>
              </a:extLst>
            </p:cNvPr>
            <p:cNvCxnSpPr/>
            <p:nvPr/>
          </p:nvCxnSpPr>
          <p:spPr>
            <a:xfrm flipH="1">
              <a:off x="7647266" y="4711700"/>
              <a:ext cx="4235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0DBBC791-D4A6-439D-A2C3-F02D2C473CEE}"/>
                </a:ext>
              </a:extLst>
            </p:cNvPr>
            <p:cNvCxnSpPr/>
            <p:nvPr/>
          </p:nvCxnSpPr>
          <p:spPr>
            <a:xfrm>
              <a:off x="7647266" y="4711700"/>
              <a:ext cx="0" cy="609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1">
              <a:extLst>
                <a:ext uri="{FF2B5EF4-FFF2-40B4-BE49-F238E27FC236}">
                  <a16:creationId xmlns:a16="http://schemas.microsoft.com/office/drawing/2014/main" id="{10DA3646-97F0-4D5B-9DC8-6BDB238312E6}"/>
                </a:ext>
              </a:extLst>
            </p:cNvPr>
            <p:cNvSpPr txBox="1"/>
            <p:nvPr/>
          </p:nvSpPr>
          <p:spPr>
            <a:xfrm>
              <a:off x="7740535" y="4489077"/>
              <a:ext cx="343094" cy="336924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*</a:t>
              </a:r>
            </a:p>
          </p:txBody>
        </p:sp>
      </p:grpSp>
      <p:sp>
        <p:nvSpPr>
          <p:cNvPr id="87" name="TextBox 86"/>
          <p:cNvSpPr txBox="1"/>
          <p:nvPr/>
        </p:nvSpPr>
        <p:spPr>
          <a:xfrm>
            <a:off x="3807429" y="3698167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/>
              <a:t>N.S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896246" y="3689931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/>
              <a:t>N.S</a:t>
            </a:r>
          </a:p>
        </p:txBody>
      </p:sp>
      <p:sp>
        <p:nvSpPr>
          <p:cNvPr id="4" name="Oval 3"/>
          <p:cNvSpPr/>
          <p:nvPr/>
        </p:nvSpPr>
        <p:spPr>
          <a:xfrm>
            <a:off x="750277" y="992554"/>
            <a:ext cx="140677" cy="304800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38" name="TextBox 37"/>
          <p:cNvSpPr txBox="1"/>
          <p:nvPr/>
        </p:nvSpPr>
        <p:spPr>
          <a:xfrm>
            <a:off x="4448175" y="4819650"/>
            <a:ext cx="569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dirty="0"/>
              <a:t>ACTIN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163652" y="556411"/>
            <a:ext cx="5170100" cy="2638412"/>
            <a:chOff x="1250740" y="556411"/>
            <a:chExt cx="5170100" cy="2638412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5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37" t="58141" b="23235"/>
            <a:stretch/>
          </p:blipFill>
          <p:spPr>
            <a:xfrm>
              <a:off x="3368841" y="2372630"/>
              <a:ext cx="1224000" cy="330735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/>
            </p:cNvPicPr>
            <p:nvPr/>
          </p:nvPicPr>
          <p:blipFill rotWithShape="1">
            <a:blip r:embed="rId7">
              <a:grayscl/>
            </a:blip>
            <a:srcRect l="32396" t="15281" r="3526" b="68718"/>
            <a:stretch/>
          </p:blipFill>
          <p:spPr>
            <a:xfrm>
              <a:off x="3368040" y="1994537"/>
              <a:ext cx="1224000" cy="3240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8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02" t="24059" r="19636" b="42925"/>
            <a:stretch/>
          </p:blipFill>
          <p:spPr>
            <a:xfrm>
              <a:off x="5196839" y="1992631"/>
              <a:ext cx="1224000" cy="311563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10">
              <a:grayscl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79" t="13329" r="21290" b="40976"/>
            <a:stretch/>
          </p:blipFill>
          <p:spPr>
            <a:xfrm>
              <a:off x="5196840" y="2331721"/>
              <a:ext cx="1224000" cy="261736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12">
              <a:grayscl/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20000"/>
                      </a14:imgEffect>
                    </a14:imgLayer>
                  </a14:imgProps>
                </a:ext>
              </a:extLst>
            </a:blip>
            <a:srcRect l="37375" t="33587" r="22225" b="39585"/>
            <a:stretch/>
          </p:blipFill>
          <p:spPr>
            <a:xfrm>
              <a:off x="1285873" y="1981200"/>
              <a:ext cx="1224000" cy="81281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14">
              <a:grayscl/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43794" t="46144" r="9846" b="36979"/>
            <a:stretch/>
          </p:blipFill>
          <p:spPr>
            <a:xfrm>
              <a:off x="1285874" y="2857500"/>
              <a:ext cx="1224000" cy="337323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1104899" y="710684"/>
              <a:ext cx="1492012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LKO Un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LKO BFA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ATF6 KD Un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ATF6 KD BFA</a:t>
              </a:r>
              <a:endParaRPr lang="en-IE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3201493" y="710684"/>
              <a:ext cx="1508875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LKO Un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LKO BFA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ERK KD Un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ERK KD BFA</a:t>
              </a:r>
              <a:endParaRPr lang="en-IE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5028690" y="720209"/>
              <a:ext cx="1512081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LKO Un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PLKO BFA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XBP1 KD Un</a:t>
              </a:r>
            </a:p>
            <a:p>
              <a:pPr>
                <a:lnSpc>
                  <a:spcPct val="150000"/>
                </a:lnSpc>
              </a:pPr>
              <a:r>
                <a:rPr lang="en-IE" sz="1200" dirty="0" smtClean="0"/>
                <a:t>HCT116 XBP1 KD BFA</a:t>
              </a:r>
              <a:endParaRPr lang="en-IE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473778" y="1996168"/>
              <a:ext cx="71442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ATF6 (F)</a:t>
              </a:r>
            </a:p>
            <a:p>
              <a:endParaRPr lang="en-IE" sz="1200" dirty="0"/>
            </a:p>
            <a:p>
              <a:r>
                <a:rPr lang="en-IE" sz="1200" dirty="0" smtClean="0"/>
                <a:t>ATF6 </a:t>
              </a:r>
              <a:r>
                <a:rPr lang="en-IE" sz="1200" dirty="0"/>
                <a:t>(N)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466976" y="2860226"/>
              <a:ext cx="5690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ACTIN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513490" y="2403027"/>
              <a:ext cx="5690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/>
                <a:t>ACTIN</a:t>
              </a: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6276973" y="2326822"/>
            <a:ext cx="569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dirty="0"/>
              <a:t>ACTIN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420960" y="1937658"/>
            <a:ext cx="6303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dirty="0"/>
              <a:t>P-PERK</a:t>
            </a:r>
          </a:p>
          <a:p>
            <a:r>
              <a:rPr lang="en-IE" sz="1200" dirty="0"/>
              <a:t>PERK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6259290" y="2022025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dirty="0"/>
              <a:t>XBP1s</a:t>
            </a:r>
          </a:p>
        </p:txBody>
      </p:sp>
    </p:spTree>
    <p:extLst>
      <p:ext uri="{BB962C8B-B14F-4D97-AF65-F5344CB8AC3E}">
        <p14:creationId xmlns:p14="http://schemas.microsoft.com/office/powerpoint/2010/main" val="14657320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2628" y="9525"/>
            <a:ext cx="6858594" cy="686621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581900" y="4145340"/>
            <a:ext cx="4410075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E" sz="1200" dirty="0"/>
              <a:t>Supplementary figure 4. </a:t>
            </a:r>
            <a:r>
              <a:rPr lang="en-IE" sz="1200" b="1" dirty="0"/>
              <a:t>Identification of potential XBP1-binding site in the promoter region of PPARGC1B</a:t>
            </a:r>
            <a:r>
              <a:rPr lang="en-IE" sz="1200" dirty="0"/>
              <a:t>. (A) The sequence of promoter region of human PPARGC1B is shown. The transcription start site is shown in red and predicted XBP1-binding site is bold and underlined. (B) Analysis of PPARGC1B promoter using CiiiDER, a tool for predicting and analysing transcription factor binding sites (http://ciiider.org/) identified a XBP1-binding site at -435 to -422 relative to transcription start site. (C) XBP1 binding motif from JASPAR database (MA0844.1) and frequency matrix is shown. The sequence of predicted XBP1-binding site in PPARGC1B promoter is shown.</a:t>
            </a:r>
          </a:p>
        </p:txBody>
      </p:sp>
    </p:spTree>
    <p:extLst>
      <p:ext uri="{BB962C8B-B14F-4D97-AF65-F5344CB8AC3E}">
        <p14:creationId xmlns:p14="http://schemas.microsoft.com/office/powerpoint/2010/main" val="23276678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24032" y="371158"/>
            <a:ext cx="11089225" cy="5117590"/>
            <a:chOff x="209844" y="412348"/>
            <a:chExt cx="11089225" cy="5117590"/>
          </a:xfrm>
        </p:grpSpPr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B5F63909-3971-4F88-A91C-23516E45B321}"/>
                </a:ext>
              </a:extLst>
            </p:cNvPr>
            <p:cNvSpPr txBox="1"/>
            <p:nvPr/>
          </p:nvSpPr>
          <p:spPr>
            <a:xfrm>
              <a:off x="209844" y="4698941"/>
              <a:ext cx="1108922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upplementary figure 5. </a:t>
              </a:r>
              <a:r>
                <a:rPr lang="en-US" sz="1200" b="1" dirty="0"/>
                <a:t>Generation and characterization of miR-378 expressing sub-clones. </a:t>
              </a:r>
              <a:r>
                <a:rPr lang="en-US" sz="1200" dirty="0"/>
                <a:t>Indicated cell lines were transduced with lentivirus encoding for either GFP alone or GFP + miR-378. After puromycin (1µg/ml) selection for one week the cells were used for analysis. (</a:t>
              </a:r>
              <a:r>
                <a:rPr lang="en-US" sz="1200" b="1" dirty="0"/>
                <a:t>A</a:t>
              </a:r>
              <a:r>
                <a:rPr lang="en-US" sz="1200" dirty="0"/>
                <a:t>) Bright field and fluorescent images of respective control and miR-378 expressing cells are shown. (</a:t>
              </a:r>
              <a:r>
                <a:rPr lang="en-US" sz="1200" b="1" dirty="0"/>
                <a:t>B</a:t>
              </a:r>
              <a:r>
                <a:rPr lang="en-US" sz="1200" dirty="0"/>
                <a:t>) RNU6b normalized </a:t>
              </a:r>
              <a:r>
                <a:rPr lang="en-IE" sz="1200" dirty="0"/>
                <a:t>expression of miR-378 as determined by real-time RT-PCR in control (</a:t>
              </a:r>
              <a:r>
                <a:rPr lang="en-IE" sz="1200" dirty="0" err="1"/>
                <a:t>miR</a:t>
              </a:r>
              <a:r>
                <a:rPr lang="en-IE" sz="1200" dirty="0"/>
                <a:t>-CTRL) and miR-378 expressing subclones of MCF7, ZR-75-1, MDA-MB231 and HCT116 cells is shown. </a:t>
              </a:r>
              <a:endParaRPr lang="en-US" sz="1200" dirty="0"/>
            </a:p>
          </p:txBody>
        </p:sp>
        <p:graphicFrame>
          <p:nvGraphicFramePr>
            <p:cNvPr id="48" name="Chart 47">
              <a:extLst>
                <a:ext uri="{FF2B5EF4-FFF2-40B4-BE49-F238E27FC236}">
                  <a16:creationId xmlns:a16="http://schemas.microsoft.com/office/drawing/2014/main" id="{846F4364-F347-4585-869D-B108864B537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24141375"/>
                </p:ext>
              </p:extLst>
            </p:nvPr>
          </p:nvGraphicFramePr>
          <p:xfrm>
            <a:off x="352616" y="2661580"/>
            <a:ext cx="2355502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7" name="Chart 46">
              <a:extLst>
                <a:ext uri="{FF2B5EF4-FFF2-40B4-BE49-F238E27FC236}">
                  <a16:creationId xmlns:a16="http://schemas.microsoft.com/office/drawing/2014/main" id="{B00062BC-0CB3-47F3-9038-15864C20D0E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34730424"/>
                </p:ext>
              </p:extLst>
            </p:nvPr>
          </p:nvGraphicFramePr>
          <p:xfrm>
            <a:off x="5973991" y="2657156"/>
            <a:ext cx="2311568" cy="21169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3C58C4B-468C-40A7-BF65-6804F94A611F}"/>
                </a:ext>
              </a:extLst>
            </p:cNvPr>
            <p:cNvSpPr txBox="1"/>
            <p:nvPr/>
          </p:nvSpPr>
          <p:spPr>
            <a:xfrm>
              <a:off x="7502635" y="2827632"/>
              <a:ext cx="264453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dirty="0"/>
                <a:t>*</a:t>
              </a:r>
            </a:p>
          </p:txBody>
        </p:sp>
        <p:graphicFrame>
          <p:nvGraphicFramePr>
            <p:cNvPr id="44" name="Chart 43">
              <a:extLst>
                <a:ext uri="{FF2B5EF4-FFF2-40B4-BE49-F238E27FC236}">
                  <a16:creationId xmlns:a16="http://schemas.microsoft.com/office/drawing/2014/main" id="{00BB57F2-8A16-4335-A7A3-563EF870296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08358915"/>
                </p:ext>
              </p:extLst>
            </p:nvPr>
          </p:nvGraphicFramePr>
          <p:xfrm>
            <a:off x="8803872" y="2664978"/>
            <a:ext cx="2325175" cy="21091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0" name="Chart 49">
              <a:extLst>
                <a:ext uri="{FF2B5EF4-FFF2-40B4-BE49-F238E27FC236}">
                  <a16:creationId xmlns:a16="http://schemas.microsoft.com/office/drawing/2014/main" id="{33E17CDD-184C-4FDA-A06B-EFB3EEC2CFE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13150021"/>
                </p:ext>
              </p:extLst>
            </p:nvPr>
          </p:nvGraphicFramePr>
          <p:xfrm>
            <a:off x="3109472" y="2661581"/>
            <a:ext cx="2403221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51" name="TextBox 4">
              <a:extLst>
                <a:ext uri="{FF2B5EF4-FFF2-40B4-BE49-F238E27FC236}">
                  <a16:creationId xmlns:a16="http://schemas.microsoft.com/office/drawing/2014/main" id="{D2C24B9B-2041-43AF-A0F7-D8BC20B86EDD}"/>
                </a:ext>
              </a:extLst>
            </p:cNvPr>
            <p:cNvSpPr txBox="1"/>
            <p:nvPr/>
          </p:nvSpPr>
          <p:spPr>
            <a:xfrm>
              <a:off x="4716207" y="2726577"/>
              <a:ext cx="222974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1" dirty="0"/>
                <a:t>*</a:t>
              </a: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427944" y="576731"/>
              <a:ext cx="10854347" cy="1917122"/>
              <a:chOff x="427944" y="769678"/>
              <a:chExt cx="10854347" cy="1917122"/>
            </a:xfrm>
          </p:grpSpPr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8D16AB2B-0FD8-42BA-81E6-5C6AE5468774}"/>
                  </a:ext>
                </a:extLst>
              </p:cNvPr>
              <p:cNvSpPr/>
              <p:nvPr/>
            </p:nvSpPr>
            <p:spPr>
              <a:xfrm>
                <a:off x="448747" y="781061"/>
                <a:ext cx="2378199" cy="24622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cs typeface="Arial" panose="020B0604020202020204" pitchFamily="34" charset="0"/>
                  </a:rPr>
                  <a:t>MCF7-miR-CTRL              MCF7-miR-378                                                                   </a:t>
                </a:r>
                <a:endParaRPr lang="en-US" sz="1000" dirty="0"/>
              </a:p>
            </p:txBody>
          </p:sp>
          <p:pic>
            <p:nvPicPr>
              <p:cNvPr id="41" name="Picture 40"/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7944" y="977409"/>
                <a:ext cx="1113799" cy="835349"/>
              </a:xfrm>
              <a:prstGeom prst="rect">
                <a:avLst/>
              </a:prstGeom>
            </p:spPr>
          </p:pic>
          <p:pic>
            <p:nvPicPr>
              <p:cNvPr id="42" name="Picture 41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7944" y="1849275"/>
                <a:ext cx="1113745" cy="835309"/>
              </a:xfrm>
              <a:prstGeom prst="rect">
                <a:avLst/>
              </a:prstGeom>
            </p:spPr>
          </p:pic>
          <p:pic>
            <p:nvPicPr>
              <p:cNvPr id="45" name="Picture 44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8085" y="1849275"/>
                <a:ext cx="1113745" cy="835309"/>
              </a:xfrm>
              <a:prstGeom prst="rect">
                <a:avLst/>
              </a:prstGeom>
            </p:spPr>
          </p:pic>
          <p:pic>
            <p:nvPicPr>
              <p:cNvPr id="46" name="Picture 45"/>
              <p:cNvPicPr>
                <a:picLocks noChangeAspect="1"/>
              </p:cNvPicPr>
              <p:nvPr/>
            </p:nvPicPr>
            <p:blipFill>
              <a:blip r:embed="rId10" cstate="hq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8085" y="977449"/>
                <a:ext cx="1113745" cy="835309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FA9AF3D-D17E-401C-A819-8A46B65828EA}"/>
                  </a:ext>
                </a:extLst>
              </p:cNvPr>
              <p:cNvSpPr txBox="1"/>
              <p:nvPr/>
            </p:nvSpPr>
            <p:spPr>
              <a:xfrm>
                <a:off x="5846864" y="769678"/>
                <a:ext cx="2753339" cy="254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MDA-MB-231-miR-CTRL   MDA-MB-231-miR-378</a:t>
                </a:r>
              </a:p>
            </p:txBody>
          </p:sp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15E1B09A-7CDF-4AA1-BB56-9B212E33F4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56628" y="1849841"/>
                <a:ext cx="1115391" cy="836543"/>
              </a:xfrm>
              <a:prstGeom prst="rect">
                <a:avLst/>
              </a:prstGeom>
            </p:spPr>
          </p:pic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F2552F03-BFBA-4BAC-9FB4-148989ACE2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hq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56628" y="976579"/>
                <a:ext cx="1115391" cy="836543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73ADF413-2F8F-44DA-A8A1-84158FD1EF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hq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94427" y="976579"/>
                <a:ext cx="1115391" cy="836543"/>
              </a:xfrm>
              <a:prstGeom prst="rect">
                <a:avLst/>
              </a:prstGeom>
            </p:spPr>
          </p:pic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9245FB2E-569A-49E7-9849-0D8404F037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hq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94427" y="1849841"/>
                <a:ext cx="1115391" cy="836543"/>
              </a:xfrm>
              <a:prstGeom prst="rect">
                <a:avLst/>
              </a:prstGeom>
            </p:spPr>
          </p:pic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3035E729-D334-42DD-8437-6C65DF359FEF}"/>
                  </a:ext>
                </a:extLst>
              </p:cNvPr>
              <p:cNvSpPr/>
              <p:nvPr/>
            </p:nvSpPr>
            <p:spPr>
              <a:xfrm>
                <a:off x="8677722" y="772440"/>
                <a:ext cx="2604569" cy="25391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cs typeface="Arial" panose="020B0604020202020204" pitchFamily="34" charset="0"/>
                  </a:rPr>
                  <a:t>       HCT116-miR-CTRL        HCT116-miR-378                                                              </a:t>
                </a:r>
                <a:endParaRPr lang="en-US" sz="1000" dirty="0"/>
              </a:p>
            </p:txBody>
          </p:sp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29DC67C5-A63B-4FCC-803D-A08DAC7BF7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hq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002315" y="972620"/>
                <a:ext cx="1119916" cy="839940"/>
              </a:xfrm>
              <a:prstGeom prst="rect">
                <a:avLst/>
              </a:prstGeom>
            </p:spPr>
          </p:pic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811F1208-6C00-4659-9B88-7E650ADBAA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hq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002315" y="1838716"/>
                <a:ext cx="1119916" cy="839940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9F52F7B2-66F4-47FF-8F55-D4F4292D03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hq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51685" y="1838716"/>
                <a:ext cx="1119513" cy="839940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6109DF08-34DD-4161-9703-6485A4D5376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6" cstate="hqprint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51685" y="972620"/>
                <a:ext cx="1120791" cy="839940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10F785A-3260-490A-BEAC-926CD81621F2}"/>
                  </a:ext>
                </a:extLst>
              </p:cNvPr>
              <p:cNvSpPr txBox="1"/>
              <p:nvPr/>
            </p:nvSpPr>
            <p:spPr>
              <a:xfrm>
                <a:off x="2972099" y="774600"/>
                <a:ext cx="29004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          ZR-75-1-miR-CTRL        ZR-75-1-miR-378</a:t>
                </a:r>
              </a:p>
            </p:txBody>
          </p:sp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082F7571-5D55-49F4-8968-1F7857FD5A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 cstate="hqprint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4756" y="979929"/>
                <a:ext cx="1115291" cy="836466"/>
              </a:xfrm>
              <a:prstGeom prst="rect">
                <a:avLst/>
              </a:prstGeom>
            </p:spPr>
          </p:pic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BF3376B7-C31B-49EC-9D37-8E48DADF1A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 cstate="hq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4756" y="1850334"/>
                <a:ext cx="1115291" cy="836466"/>
              </a:xfrm>
              <a:prstGeom prst="rect">
                <a:avLst/>
              </a:prstGeom>
            </p:spPr>
          </p:pic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E7BFC98D-DFBD-4C9B-95FB-01301184AD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 cstate="hqprint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98854" y="979929"/>
                <a:ext cx="1115291" cy="836466"/>
              </a:xfrm>
              <a:prstGeom prst="rect">
                <a:avLst/>
              </a:prstGeom>
            </p:spPr>
          </p:pic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9E9B8867-9265-4436-959F-548285D868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 cstate="hqprint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88901" y="1850334"/>
                <a:ext cx="1115291" cy="836466"/>
              </a:xfrm>
              <a:prstGeom prst="rect">
                <a:avLst/>
              </a:prstGeom>
            </p:spPr>
          </p:pic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72B019B-C6CE-4D1E-B175-2788CB7D2EA8}"/>
                </a:ext>
              </a:extLst>
            </p:cNvPr>
            <p:cNvSpPr txBox="1"/>
            <p:nvPr/>
          </p:nvSpPr>
          <p:spPr>
            <a:xfrm>
              <a:off x="259564" y="412348"/>
              <a:ext cx="221805" cy="2462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A                                                                   </a:t>
              </a:r>
            </a:p>
            <a:p>
              <a:endParaRPr lang="en-US" sz="1400" b="1" dirty="0"/>
            </a:p>
            <a:p>
              <a:endParaRPr lang="en-US" sz="1400" b="1" dirty="0"/>
            </a:p>
            <a:p>
              <a:endParaRPr lang="en-US" sz="1400" b="1" dirty="0"/>
            </a:p>
            <a:p>
              <a:endParaRPr lang="en-US" sz="1400" b="1" dirty="0"/>
            </a:p>
            <a:p>
              <a:endParaRPr lang="en-US" sz="1400" b="1" dirty="0"/>
            </a:p>
            <a:p>
              <a:endParaRPr lang="en-US" sz="1400" b="1" dirty="0"/>
            </a:p>
            <a:p>
              <a:endParaRPr lang="en-US" sz="1400" b="1" dirty="0"/>
            </a:p>
            <a:p>
              <a:endParaRPr lang="en-US" sz="1400" b="1" dirty="0"/>
            </a:p>
            <a:p>
              <a:endParaRPr lang="en-US" sz="1400" b="1" dirty="0"/>
            </a:p>
            <a:p>
              <a:r>
                <a:rPr lang="en-US" sz="1400" b="1" dirty="0"/>
                <a:t>B        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253670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Box 84">
            <a:extLst>
              <a:ext uri="{FF2B5EF4-FFF2-40B4-BE49-F238E27FC236}">
                <a16:creationId xmlns:a16="http://schemas.microsoft.com/office/drawing/2014/main" id="{B5F63909-3971-4F88-A91C-23516E45B321}"/>
              </a:ext>
            </a:extLst>
          </p:cNvPr>
          <p:cNvSpPr txBox="1"/>
          <p:nvPr/>
        </p:nvSpPr>
        <p:spPr>
          <a:xfrm>
            <a:off x="849617" y="3635604"/>
            <a:ext cx="106349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ry figure 6. </a:t>
            </a:r>
            <a:r>
              <a:rPr lang="en-US" sz="1200" b="1" dirty="0"/>
              <a:t>Effect of miR-378 expression on unfolded protein response in HCT116. </a:t>
            </a:r>
            <a:r>
              <a:rPr lang="en-IE" sz="1200" dirty="0"/>
              <a:t>Control and miR-378 expressing HCT116 sub-clones </a:t>
            </a:r>
            <a:r>
              <a:rPr lang="en-US" sz="1200" dirty="0"/>
              <a:t>were either untreated or treated with </a:t>
            </a:r>
            <a:r>
              <a:rPr lang="en-IE" sz="1200" dirty="0"/>
              <a:t>(0.5</a:t>
            </a:r>
            <a:r>
              <a:rPr lang="en-IE" sz="1200" dirty="0">
                <a:sym typeface="Symbol" panose="05050102010706020507" pitchFamily="18" charset="2"/>
              </a:rPr>
              <a:t></a:t>
            </a:r>
            <a:r>
              <a:rPr lang="en-IE" sz="1200" dirty="0"/>
              <a:t>g/ml) BFA for 8 and 24 hours.</a:t>
            </a:r>
            <a:r>
              <a:rPr lang="en-IE" sz="1200" b="1" dirty="0"/>
              <a:t> </a:t>
            </a:r>
            <a:r>
              <a:rPr lang="en-US" sz="1200" dirty="0"/>
              <a:t>The change in expression levels of ER stress markers </a:t>
            </a:r>
            <a:r>
              <a:rPr lang="en-US" sz="1200" b="1" dirty="0"/>
              <a:t>(A) </a:t>
            </a:r>
            <a:r>
              <a:rPr lang="en-US" sz="1200" dirty="0"/>
              <a:t>XBP1 and </a:t>
            </a:r>
            <a:r>
              <a:rPr lang="en-US" sz="1200" b="1" dirty="0"/>
              <a:t>(B) </a:t>
            </a:r>
            <a:r>
              <a:rPr lang="en-US" sz="1200" dirty="0"/>
              <a:t>GRP78, HERP, and CHOP were quantified by PCR and RT-qPCR, normalizing against GAPDH. Error bars represent mean </a:t>
            </a:r>
            <a:r>
              <a:rPr lang="en-GB" sz="1200" dirty="0"/>
              <a:t>±</a:t>
            </a:r>
            <a:r>
              <a:rPr lang="en-US" sz="1200" dirty="0"/>
              <a:t>S.D. from three independent experiments performed in triplicate. N.S, not significant.</a:t>
            </a:r>
            <a:endParaRPr lang="en-US" sz="1200" b="1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A4A3EF2-EAD4-40AC-8D1E-8ED60AA8264D}"/>
              </a:ext>
            </a:extLst>
          </p:cNvPr>
          <p:cNvSpPr txBox="1"/>
          <p:nvPr/>
        </p:nvSpPr>
        <p:spPr>
          <a:xfrm>
            <a:off x="1030596" y="879942"/>
            <a:ext cx="48173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                                                                   B                                         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D02E2058-E1FB-48D2-D8E0-C87FB2A22B2B}"/>
              </a:ext>
            </a:extLst>
          </p:cNvPr>
          <p:cNvGrpSpPr/>
          <p:nvPr/>
        </p:nvGrpSpPr>
        <p:grpSpPr>
          <a:xfrm>
            <a:off x="945014" y="1453708"/>
            <a:ext cx="10397369" cy="2297430"/>
            <a:chOff x="945014" y="1445757"/>
            <a:chExt cx="10397369" cy="2297430"/>
          </a:xfrm>
        </p:grpSpPr>
        <p:grpSp>
          <p:nvGrpSpPr>
            <p:cNvPr id="84" name="Group 83"/>
            <p:cNvGrpSpPr/>
            <p:nvPr/>
          </p:nvGrpSpPr>
          <p:grpSpPr>
            <a:xfrm>
              <a:off x="945014" y="1569762"/>
              <a:ext cx="2996297" cy="1856777"/>
              <a:chOff x="857703" y="2643305"/>
              <a:chExt cx="2996297" cy="1856777"/>
            </a:xfrm>
          </p:grpSpPr>
          <p:grpSp>
            <p:nvGrpSpPr>
              <p:cNvPr id="83" name="Group 82"/>
              <p:cNvGrpSpPr/>
              <p:nvPr/>
            </p:nvGrpSpPr>
            <p:grpSpPr>
              <a:xfrm>
                <a:off x="857703" y="2643305"/>
                <a:ext cx="2996297" cy="1856777"/>
                <a:chOff x="857703" y="2643305"/>
                <a:chExt cx="2996297" cy="1856777"/>
              </a:xfrm>
            </p:grpSpPr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0E8FA6DF-262B-4500-9ADF-B5447CC71589}"/>
                    </a:ext>
                  </a:extLst>
                </p:cNvPr>
                <p:cNvGrpSpPr/>
                <p:nvPr/>
              </p:nvGrpSpPr>
              <p:grpSpPr>
                <a:xfrm>
                  <a:off x="1331592" y="2643305"/>
                  <a:ext cx="2522408" cy="1856777"/>
                  <a:chOff x="7222534" y="4165092"/>
                  <a:chExt cx="2522408" cy="1856777"/>
                </a:xfrm>
              </p:grpSpPr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B73E0AF8-CE9C-4E4D-A160-102C35E61576}"/>
                      </a:ext>
                    </a:extLst>
                  </p:cNvPr>
                  <p:cNvSpPr txBox="1"/>
                  <p:nvPr/>
                </p:nvSpPr>
                <p:spPr bwMode="auto">
                  <a:xfrm>
                    <a:off x="8856098" y="5791037"/>
                    <a:ext cx="601447" cy="23083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>
                      <a:defRPr/>
                    </a:pPr>
                    <a:r>
                      <a:rPr lang="en-US" sz="900" dirty="0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GAPDH</a:t>
                    </a: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8638712F-178B-4E34-BE31-6B70B9A8CD8A}"/>
                      </a:ext>
                    </a:extLst>
                  </p:cNvPr>
                  <p:cNvSpPr txBox="1"/>
                  <p:nvPr/>
                </p:nvSpPr>
                <p:spPr bwMode="auto">
                  <a:xfrm>
                    <a:off x="8846939" y="4899225"/>
                    <a:ext cx="898003" cy="646331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/>
                  <a:p>
                    <a:pPr>
                      <a:defRPr/>
                    </a:pPr>
                    <a:r>
                      <a:rPr lang="en-US" sz="900" dirty="0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XBP1 </a:t>
                    </a:r>
                    <a:r>
                      <a:rPr lang="en-US" sz="900" dirty="0" err="1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unspliced</a:t>
                    </a:r>
                    <a:endParaRPr lang="en-US" sz="900" dirty="0">
                      <a:solidFill>
                        <a:prstClr val="black"/>
                      </a:solidFill>
                      <a:cs typeface="Times New Roman" panose="02020603050405020304" pitchFamily="18" charset="0"/>
                    </a:endParaRPr>
                  </a:p>
                  <a:p>
                    <a:pPr>
                      <a:defRPr/>
                    </a:pPr>
                    <a:endParaRPr lang="en-US" sz="900" dirty="0">
                      <a:solidFill>
                        <a:prstClr val="black"/>
                      </a:solidFill>
                      <a:cs typeface="Times New Roman" panose="02020603050405020304" pitchFamily="18" charset="0"/>
                    </a:endParaRPr>
                  </a:p>
                  <a:p>
                    <a:pPr>
                      <a:defRPr/>
                    </a:pPr>
                    <a:endParaRPr lang="en-US" sz="900" dirty="0">
                      <a:solidFill>
                        <a:prstClr val="black"/>
                      </a:solidFill>
                      <a:cs typeface="Times New Roman" panose="02020603050405020304" pitchFamily="18" charset="0"/>
                    </a:endParaRPr>
                  </a:p>
                  <a:p>
                    <a:pPr>
                      <a:defRPr/>
                    </a:pPr>
                    <a:r>
                      <a:rPr lang="en-US" sz="900" dirty="0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XBP1 spliced</a:t>
                    </a: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B0139B5F-648D-4230-A09E-492F0CF4B178}"/>
                      </a:ext>
                    </a:extLst>
                  </p:cNvPr>
                  <p:cNvSpPr txBox="1"/>
                  <p:nvPr/>
                </p:nvSpPr>
                <p:spPr bwMode="auto">
                  <a:xfrm>
                    <a:off x="7222534" y="4165644"/>
                    <a:ext cx="707915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>
                      <a:defRPr/>
                    </a:pPr>
                    <a:r>
                      <a:rPr lang="en-US" sz="1000" dirty="0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HCT116</a:t>
                    </a:r>
                  </a:p>
                  <a:p>
                    <a:pPr algn="ctr">
                      <a:defRPr/>
                    </a:pPr>
                    <a:r>
                      <a:rPr lang="en-US" sz="1000" dirty="0" err="1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miR</a:t>
                    </a:r>
                    <a:r>
                      <a:rPr lang="en-US" sz="1000" dirty="0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-CTRL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F57507F3-BC3D-40F9-A19F-579F7359A690}"/>
                      </a:ext>
                    </a:extLst>
                  </p:cNvPr>
                  <p:cNvSpPr txBox="1"/>
                  <p:nvPr/>
                </p:nvSpPr>
                <p:spPr bwMode="auto">
                  <a:xfrm rot="10800000" flipV="1">
                    <a:off x="8020897" y="4165092"/>
                    <a:ext cx="741183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>
                      <a:defRPr/>
                    </a:pPr>
                    <a:r>
                      <a:rPr lang="en-US" sz="1000" dirty="0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HCT116</a:t>
                    </a:r>
                  </a:p>
                  <a:p>
                    <a:pPr algn="ctr">
                      <a:defRPr/>
                    </a:pPr>
                    <a:r>
                      <a:rPr lang="en-US" sz="1000" dirty="0">
                        <a:solidFill>
                          <a:prstClr val="black"/>
                        </a:solidFill>
                        <a:cs typeface="Times New Roman" panose="02020603050405020304" pitchFamily="18" charset="0"/>
                      </a:rPr>
                      <a:t>miR-378</a:t>
                    </a:r>
                  </a:p>
                </p:txBody>
              </p:sp>
            </p:grpSp>
            <p:sp>
              <p:nvSpPr>
                <p:cNvPr id="80" name="TextBox 79"/>
                <p:cNvSpPr txBox="1"/>
                <p:nvPr/>
              </p:nvSpPr>
              <p:spPr>
                <a:xfrm>
                  <a:off x="857703" y="2973976"/>
                  <a:ext cx="213872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E" sz="1100" dirty="0"/>
                    <a:t>BFA     0      8       24     0       8      24</a:t>
                  </a:r>
                </a:p>
              </p:txBody>
            </p:sp>
          </p:grpSp>
          <p:cxnSp>
            <p:nvCxnSpPr>
              <p:cNvPr id="81" name="Straight Connector 80"/>
              <p:cNvCxnSpPr/>
              <p:nvPr/>
            </p:nvCxnSpPr>
            <p:spPr>
              <a:xfrm>
                <a:off x="1294793" y="2983837"/>
                <a:ext cx="72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2138288" y="2983830"/>
                <a:ext cx="72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1DD8607B-F978-68BD-8DCC-5D566F3E6971}"/>
                </a:ext>
              </a:extLst>
            </p:cNvPr>
            <p:cNvGrpSpPr/>
            <p:nvPr/>
          </p:nvGrpSpPr>
          <p:grpSpPr>
            <a:xfrm>
              <a:off x="3708691" y="1547187"/>
              <a:ext cx="2160000" cy="2196000"/>
              <a:chOff x="3708691" y="1547187"/>
              <a:chExt cx="2160000" cy="2196000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3C61326-8C40-C462-B050-634A2F11C0C4}"/>
                  </a:ext>
                </a:extLst>
              </p:cNvPr>
              <p:cNvSpPr txBox="1"/>
              <p:nvPr/>
            </p:nvSpPr>
            <p:spPr>
              <a:xfrm>
                <a:off x="4956958" y="1759829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800" dirty="0"/>
                  <a:t>N.S</a:t>
                </a:r>
              </a:p>
            </p:txBody>
          </p: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75A1758E-70C1-6388-F7CB-2A00A0AA72DC}"/>
                  </a:ext>
                </a:extLst>
              </p:cNvPr>
              <p:cNvCxnSpPr>
                <a:stCxn id="9" idx="1"/>
                <a:endCxn id="9" idx="1"/>
              </p:cNvCxnSpPr>
              <p:nvPr/>
            </p:nvCxnSpPr>
            <p:spPr>
              <a:xfrm>
                <a:off x="4956958" y="1867551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49405168-85EB-A2F9-0362-CC1A0587C67F}"/>
                  </a:ext>
                </a:extLst>
              </p:cNvPr>
              <p:cNvGrpSpPr/>
              <p:nvPr/>
            </p:nvGrpSpPr>
            <p:grpSpPr>
              <a:xfrm>
                <a:off x="3708691" y="1547187"/>
                <a:ext cx="2160000" cy="2196000"/>
                <a:chOff x="3692130" y="1245978"/>
                <a:chExt cx="2160000" cy="2196000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556DB6F2-4431-AA78-25F4-D599286F3DDB}"/>
                    </a:ext>
                  </a:extLst>
                </p:cNvPr>
                <p:cNvGrpSpPr/>
                <p:nvPr/>
              </p:nvGrpSpPr>
              <p:grpSpPr>
                <a:xfrm>
                  <a:off x="3692130" y="1245978"/>
                  <a:ext cx="2160000" cy="2196000"/>
                  <a:chOff x="3692130" y="1245978"/>
                  <a:chExt cx="2160000" cy="2196000"/>
                </a:xfrm>
              </p:grpSpPr>
              <p:graphicFrame>
                <p:nvGraphicFramePr>
                  <p:cNvPr id="35" name="Chart 34">
                    <a:extLst>
                      <a:ext uri="{FF2B5EF4-FFF2-40B4-BE49-F238E27FC236}">
                        <a16:creationId xmlns:a16="http://schemas.microsoft.com/office/drawing/2014/main" id="{AA9EE249-871D-4F1F-AE44-FA9B247C5DBC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165597773"/>
                      </p:ext>
                    </p:extLst>
                  </p:nvPr>
                </p:nvGraphicFramePr>
                <p:xfrm>
                  <a:off x="3692130" y="1245978"/>
                  <a:ext cx="2160000" cy="2196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cxnSp>
                <p:nvCxnSpPr>
                  <p:cNvPr id="4" name="Straight Connector 3">
                    <a:extLst>
                      <a:ext uri="{FF2B5EF4-FFF2-40B4-BE49-F238E27FC236}">
                        <a16:creationId xmlns:a16="http://schemas.microsoft.com/office/drawing/2014/main" id="{6C38FA3B-2A92-98DB-0885-B9E492B108DD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303520" y="1616344"/>
                    <a:ext cx="0" cy="68246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" name="Straight Connector 5">
                    <a:extLst>
                      <a:ext uri="{FF2B5EF4-FFF2-40B4-BE49-F238E27FC236}">
                        <a16:creationId xmlns:a16="http://schemas.microsoft.com/office/drawing/2014/main" id="{D8F77FC5-9CED-FA12-9B27-7715367ACD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766679" y="1616344"/>
                    <a:ext cx="53684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39E97CEC-FB28-E5AB-7C3E-616A8EF7AFAB}"/>
                    </a:ext>
                  </a:extLst>
                </p:cNvPr>
                <p:cNvGrpSpPr/>
                <p:nvPr/>
              </p:nvGrpSpPr>
              <p:grpSpPr>
                <a:xfrm>
                  <a:off x="4944888" y="1289382"/>
                  <a:ext cx="537501" cy="295246"/>
                  <a:chOff x="4944888" y="1289382"/>
                  <a:chExt cx="537501" cy="295246"/>
                </a:xfrm>
              </p:grpSpPr>
              <p:cxnSp>
                <p:nvCxnSpPr>
                  <p:cNvPr id="11" name="Straight Connector 10">
                    <a:extLst>
                      <a:ext uri="{FF2B5EF4-FFF2-40B4-BE49-F238E27FC236}">
                        <a16:creationId xmlns:a16="http://schemas.microsoft.com/office/drawing/2014/main" id="{0176F6FB-A850-92AA-7ED7-5CD25DB62CD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4944888" y="1445757"/>
                    <a:ext cx="53750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87D5FE00-73B0-77E1-C618-B55E0A7340BF}"/>
                      </a:ext>
                    </a:extLst>
                  </p:cNvPr>
                  <p:cNvSpPr txBox="1"/>
                  <p:nvPr/>
                </p:nvSpPr>
                <p:spPr>
                  <a:xfrm>
                    <a:off x="5066445" y="1289382"/>
                    <a:ext cx="32252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IE" sz="800" dirty="0"/>
                      <a:t>N.S</a:t>
                    </a:r>
                  </a:p>
                </p:txBody>
              </p:sp>
              <p:cxnSp>
                <p:nvCxnSpPr>
                  <p:cNvPr id="16" name="Straight Connector 15">
                    <a:extLst>
                      <a:ext uri="{FF2B5EF4-FFF2-40B4-BE49-F238E27FC236}">
                        <a16:creationId xmlns:a16="http://schemas.microsoft.com/office/drawing/2014/main" id="{5EAEBFD2-DA84-1676-BEF5-BEABFA657DE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44888" y="1445757"/>
                    <a:ext cx="0" cy="138871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Connector 17">
                    <a:extLst>
                      <a:ext uri="{FF2B5EF4-FFF2-40B4-BE49-F238E27FC236}">
                        <a16:creationId xmlns:a16="http://schemas.microsoft.com/office/drawing/2014/main" id="{611E7742-DACD-24BA-2171-C3C95653925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82298" y="1445757"/>
                    <a:ext cx="0" cy="107722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D5EF044D-7FFA-A2A8-2EC4-5DEB717DA0DD}"/>
                </a:ext>
              </a:extLst>
            </p:cNvPr>
            <p:cNvGrpSpPr/>
            <p:nvPr/>
          </p:nvGrpSpPr>
          <p:grpSpPr>
            <a:xfrm>
              <a:off x="5725274" y="1495383"/>
              <a:ext cx="2196000" cy="2176126"/>
              <a:chOff x="5703867" y="1201440"/>
              <a:chExt cx="2196000" cy="2176126"/>
            </a:xfrm>
          </p:grpSpPr>
          <p:graphicFrame>
            <p:nvGraphicFramePr>
              <p:cNvPr id="43" name="Chart 42">
                <a:extLst>
                  <a:ext uri="{FF2B5EF4-FFF2-40B4-BE49-F238E27FC236}">
                    <a16:creationId xmlns:a16="http://schemas.microsoft.com/office/drawing/2014/main" id="{F1229BF2-5F43-4750-ABF6-50675555462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63865933"/>
                  </p:ext>
                </p:extLst>
              </p:nvPr>
            </p:nvGraphicFramePr>
            <p:xfrm>
              <a:off x="5703867" y="1235566"/>
              <a:ext cx="2196000" cy="214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498E3E99-46AC-CC93-CC14-D3DDF8247E34}"/>
                  </a:ext>
                </a:extLst>
              </p:cNvPr>
              <p:cNvGrpSpPr/>
              <p:nvPr/>
            </p:nvGrpSpPr>
            <p:grpSpPr>
              <a:xfrm>
                <a:off x="6764653" y="1526123"/>
                <a:ext cx="561753" cy="1077480"/>
                <a:chOff x="6764653" y="1526123"/>
                <a:chExt cx="561753" cy="1077480"/>
              </a:xfrm>
            </p:grpSpPr>
            <p:cxnSp>
              <p:nvCxnSpPr>
                <p:cNvPr id="23" name="Straight Connector 22">
                  <a:extLst>
                    <a:ext uri="{FF2B5EF4-FFF2-40B4-BE49-F238E27FC236}">
                      <a16:creationId xmlns:a16="http://schemas.microsoft.com/office/drawing/2014/main" id="{BD4E7B20-4EF7-ED38-A0A2-C3AAA12577A0}"/>
                    </a:ext>
                  </a:extLst>
                </p:cNvPr>
                <p:cNvCxnSpPr/>
                <p:nvPr/>
              </p:nvCxnSpPr>
              <p:spPr>
                <a:xfrm flipV="1">
                  <a:off x="6764653" y="1526123"/>
                  <a:ext cx="0" cy="887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>
                  <a:extLst>
                    <a:ext uri="{FF2B5EF4-FFF2-40B4-BE49-F238E27FC236}">
                      <a16:creationId xmlns:a16="http://schemas.microsoft.com/office/drawing/2014/main" id="{CEA95DD4-96DC-FEED-D89A-20AE8E6942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326406" y="1526123"/>
                  <a:ext cx="0" cy="107748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C929E612-AE50-F61D-60D1-DE067F34B587}"/>
                    </a:ext>
                  </a:extLst>
                </p:cNvPr>
                <p:cNvCxnSpPr/>
                <p:nvPr/>
              </p:nvCxnSpPr>
              <p:spPr>
                <a:xfrm>
                  <a:off x="6764653" y="1526123"/>
                  <a:ext cx="56175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158F8635-C2D3-B09D-C411-B9293016AEC6}"/>
                  </a:ext>
                </a:extLst>
              </p:cNvPr>
              <p:cNvGrpSpPr/>
              <p:nvPr/>
            </p:nvGrpSpPr>
            <p:grpSpPr>
              <a:xfrm>
                <a:off x="6956626" y="1366149"/>
                <a:ext cx="561753" cy="132415"/>
                <a:chOff x="6764653" y="1526123"/>
                <a:chExt cx="561753" cy="887468"/>
              </a:xfrm>
            </p:grpSpPr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C25BE675-C929-65C8-017A-041B0E07C2FE}"/>
                    </a:ext>
                  </a:extLst>
                </p:cNvPr>
                <p:cNvCxnSpPr/>
                <p:nvPr/>
              </p:nvCxnSpPr>
              <p:spPr>
                <a:xfrm flipV="1">
                  <a:off x="6764653" y="1526123"/>
                  <a:ext cx="0" cy="887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829B81C1-A647-06F3-6858-6D23EEAB73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326406" y="1526123"/>
                  <a:ext cx="0" cy="4437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FF5383FF-6E0C-4F96-287E-49DC0E3CB961}"/>
                    </a:ext>
                  </a:extLst>
                </p:cNvPr>
                <p:cNvCxnSpPr/>
                <p:nvPr/>
              </p:nvCxnSpPr>
              <p:spPr>
                <a:xfrm>
                  <a:off x="6764653" y="1526123"/>
                  <a:ext cx="56175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5102F31-BB5A-B34A-6048-27CBF95D5AD3}"/>
                  </a:ext>
                </a:extLst>
              </p:cNvPr>
              <p:cNvSpPr txBox="1"/>
              <p:nvPr/>
            </p:nvSpPr>
            <p:spPr>
              <a:xfrm>
                <a:off x="6964472" y="1369184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800" dirty="0"/>
                  <a:t>N.S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85C5A792-D976-BD72-68AA-99864C91A0F2}"/>
                  </a:ext>
                </a:extLst>
              </p:cNvPr>
              <p:cNvSpPr txBox="1"/>
              <p:nvPr/>
            </p:nvSpPr>
            <p:spPr>
              <a:xfrm>
                <a:off x="7128808" y="1201440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800" dirty="0"/>
                  <a:t>N.S</a:t>
                </a: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CC0084E4-5FDC-B19F-430F-945307617B4E}"/>
                </a:ext>
              </a:extLst>
            </p:cNvPr>
            <p:cNvGrpSpPr/>
            <p:nvPr/>
          </p:nvGrpSpPr>
          <p:grpSpPr>
            <a:xfrm>
              <a:off x="7687892" y="1445757"/>
              <a:ext cx="3654491" cy="2297430"/>
              <a:chOff x="7666485" y="1151814"/>
              <a:chExt cx="3654491" cy="2297430"/>
            </a:xfrm>
          </p:grpSpPr>
          <p:graphicFrame>
            <p:nvGraphicFramePr>
              <p:cNvPr id="27" name="Chart 26">
                <a:extLst>
                  <a:ext uri="{FF2B5EF4-FFF2-40B4-BE49-F238E27FC236}">
                    <a16:creationId xmlns:a16="http://schemas.microsoft.com/office/drawing/2014/main" id="{38F5223A-5428-4E07-89F0-845E342707F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8695938"/>
                  </p:ext>
                </p:extLst>
              </p:nvPr>
            </p:nvGraphicFramePr>
            <p:xfrm>
              <a:off x="7666485" y="1253244"/>
              <a:ext cx="3654491" cy="2196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385188A3-2185-91F9-39A9-943724D2F081}"/>
                  </a:ext>
                </a:extLst>
              </p:cNvPr>
              <p:cNvGrpSpPr/>
              <p:nvPr/>
            </p:nvGrpSpPr>
            <p:grpSpPr>
              <a:xfrm>
                <a:off x="8779193" y="1471212"/>
                <a:ext cx="561753" cy="1077480"/>
                <a:chOff x="6764653" y="1526123"/>
                <a:chExt cx="561753" cy="1077480"/>
              </a:xfrm>
            </p:grpSpPr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3595C8DF-8FD1-CF9F-70B8-D2D7874439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764653" y="1526123"/>
                  <a:ext cx="0" cy="102861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1C20C453-C815-8F66-D44E-128C699203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326406" y="1526123"/>
                  <a:ext cx="0" cy="107748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28FF2375-33B5-BF5C-34D5-69FF80DAF67A}"/>
                    </a:ext>
                  </a:extLst>
                </p:cNvPr>
                <p:cNvCxnSpPr/>
                <p:nvPr/>
              </p:nvCxnSpPr>
              <p:spPr>
                <a:xfrm>
                  <a:off x="6764653" y="1526123"/>
                  <a:ext cx="56175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1143F83B-F613-A5E6-216E-AD5DFDE2577D}"/>
                  </a:ext>
                </a:extLst>
              </p:cNvPr>
              <p:cNvGrpSpPr/>
              <p:nvPr/>
            </p:nvGrpSpPr>
            <p:grpSpPr>
              <a:xfrm>
                <a:off x="8943320" y="1307279"/>
                <a:ext cx="561753" cy="175191"/>
                <a:chOff x="6764653" y="1526123"/>
                <a:chExt cx="561753" cy="1174160"/>
              </a:xfrm>
            </p:grpSpPr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DDE0330E-8044-B482-DFFE-B41351050229}"/>
                    </a:ext>
                  </a:extLst>
                </p:cNvPr>
                <p:cNvCxnSpPr/>
                <p:nvPr/>
              </p:nvCxnSpPr>
              <p:spPr>
                <a:xfrm flipV="1">
                  <a:off x="6764653" y="1526123"/>
                  <a:ext cx="0" cy="887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17D0BE40-4210-8F7C-454D-CC4AC0DA980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326406" y="1526123"/>
                  <a:ext cx="0" cy="117416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FAB578C9-4AF9-D02A-7978-244D2662B0D5}"/>
                    </a:ext>
                  </a:extLst>
                </p:cNvPr>
                <p:cNvCxnSpPr/>
                <p:nvPr/>
              </p:nvCxnSpPr>
              <p:spPr>
                <a:xfrm>
                  <a:off x="6764653" y="1526123"/>
                  <a:ext cx="56175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43976499-C86B-2DA8-5AD0-A8D8A7B4CDD9}"/>
                  </a:ext>
                </a:extLst>
              </p:cNvPr>
              <p:cNvSpPr txBox="1"/>
              <p:nvPr/>
            </p:nvSpPr>
            <p:spPr>
              <a:xfrm>
                <a:off x="8973746" y="1315107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800" dirty="0"/>
                  <a:t>N.S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3B139118-6E07-2A51-E355-15EFC9D90BCB}"/>
                  </a:ext>
                </a:extLst>
              </p:cNvPr>
              <p:cNvSpPr txBox="1"/>
              <p:nvPr/>
            </p:nvSpPr>
            <p:spPr>
              <a:xfrm>
                <a:off x="9101351" y="1151814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800" dirty="0"/>
                  <a:t>N.S</a:t>
                </a:r>
              </a:p>
            </p:txBody>
          </p:sp>
        </p:grpSp>
      </p:grp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90" t="48528" b="34724"/>
          <a:stretch/>
        </p:blipFill>
        <p:spPr>
          <a:xfrm>
            <a:off x="1304925" y="2162175"/>
            <a:ext cx="1760220" cy="8667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16" t="47600" b="44719"/>
          <a:stretch/>
        </p:blipFill>
        <p:spPr>
          <a:xfrm>
            <a:off x="1304924" y="3105149"/>
            <a:ext cx="1742313" cy="304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01579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603522" y="4102136"/>
            <a:ext cx="5400000" cy="2604832"/>
            <a:chOff x="6705599" y="2047057"/>
            <a:chExt cx="5436973" cy="2604832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05599" y="2047057"/>
              <a:ext cx="5436973" cy="2604832"/>
            </a:xfrm>
            <a:prstGeom prst="rect">
              <a:avLst/>
            </a:prstGeom>
            <a:ln>
              <a:noFill/>
            </a:ln>
            <a:effectLst>
              <a:outerShdw blurRad="190500" algn="tl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8" name="TextBox 7"/>
            <p:cNvSpPr txBox="1"/>
            <p:nvPr/>
          </p:nvSpPr>
          <p:spPr>
            <a:xfrm>
              <a:off x="9716428" y="2063533"/>
              <a:ext cx="2417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dirty="0"/>
                <a:t>GO </a:t>
              </a:r>
              <a:r>
                <a:rPr lang="en-IE" dirty="0" err="1"/>
                <a:t>Reactome</a:t>
              </a:r>
              <a:r>
                <a:rPr lang="en-IE" dirty="0"/>
                <a:t> pathways</a:t>
              </a:r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9DC7ADFC-B38C-4BE6-94D2-5110EEA5505E}"/>
              </a:ext>
            </a:extLst>
          </p:cNvPr>
          <p:cNvSpPr/>
          <p:nvPr/>
        </p:nvSpPr>
        <p:spPr>
          <a:xfrm>
            <a:off x="7229968" y="682083"/>
            <a:ext cx="4623676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E" sz="1200" dirty="0">
                <a:cs typeface="Times New Roman" panose="02020603050405020304" pitchFamily="18" charset="0"/>
              </a:rPr>
              <a:t>Supplementary figure 7. </a:t>
            </a:r>
            <a:r>
              <a:rPr lang="en-IE" sz="1200" b="1" dirty="0">
                <a:cs typeface="Times New Roman" panose="02020603050405020304" pitchFamily="18" charset="0"/>
              </a:rPr>
              <a:t>Analysis of the genes upregulated by miR-378 expression in MCF7 cells</a:t>
            </a:r>
            <a:r>
              <a:rPr lang="en-IE" sz="1200" dirty="0">
                <a:cs typeface="Times New Roman" panose="02020603050405020304" pitchFamily="18" charset="0"/>
              </a:rPr>
              <a:t>. 254 upregulated gene in miR-378 expressing cells were used for GO term analysis (</a:t>
            </a:r>
            <a:r>
              <a:rPr lang="en-IE" sz="1200" dirty="0">
                <a:cs typeface="Times New Roman" panose="02020603050405020304" pitchFamily="18" charset="0"/>
                <a:hlinkClick r:id="rId3"/>
              </a:rPr>
              <a:t>http://www.geneontology.org/</a:t>
            </a:r>
            <a:r>
              <a:rPr lang="en-IE" sz="1200" dirty="0">
                <a:cs typeface="Times New Roman" panose="02020603050405020304" pitchFamily="18" charset="0"/>
              </a:rPr>
              <a:t>).</a:t>
            </a:r>
            <a:r>
              <a:rPr lang="en-IE" sz="1200" dirty="0"/>
              <a:t> The reference list had 21042 mapped IDs. Of the 254 genes, 210 genes were mapped to database object IDs and 44 genes had unmapped object IDs in the database. (</a:t>
            </a:r>
            <a:r>
              <a:rPr lang="en-IE" sz="1200" b="1" dirty="0"/>
              <a:t>A</a:t>
            </a:r>
            <a:r>
              <a:rPr lang="en-IE" sz="1200" dirty="0"/>
              <a:t>) PANTHER overrepresentation Test (Released 20171205) using GO biological process complete annotation data set at FDR &lt; 0.05. (</a:t>
            </a:r>
            <a:r>
              <a:rPr lang="en-IE" sz="1200" b="1" dirty="0"/>
              <a:t>B</a:t>
            </a:r>
            <a:r>
              <a:rPr lang="en-IE" sz="1200" dirty="0"/>
              <a:t>) PANTHER overrepresentation Test (Released 20171205) using </a:t>
            </a:r>
            <a:r>
              <a:rPr lang="en-IE" sz="1200" dirty="0" err="1"/>
              <a:t>Reactome</a:t>
            </a:r>
            <a:r>
              <a:rPr lang="en-IE" sz="1200" dirty="0"/>
              <a:t> pathways annotation data set at FDR &lt; 0.05.</a:t>
            </a:r>
          </a:p>
          <a:p>
            <a:pPr algn="just"/>
            <a:endParaRPr lang="en-IE" sz="1200" dirty="0"/>
          </a:p>
          <a:p>
            <a:pPr algn="just">
              <a:defRPr/>
            </a:pPr>
            <a:endParaRPr lang="en-IE" sz="1200" dirty="0"/>
          </a:p>
        </p:txBody>
      </p:sp>
      <p:grpSp>
        <p:nvGrpSpPr>
          <p:cNvPr id="12" name="Group 11"/>
          <p:cNvGrpSpPr/>
          <p:nvPr/>
        </p:nvGrpSpPr>
        <p:grpSpPr>
          <a:xfrm>
            <a:off x="1603523" y="170979"/>
            <a:ext cx="5400000" cy="3711508"/>
            <a:chOff x="384324" y="1864839"/>
            <a:chExt cx="5938775" cy="3735681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324" y="1864839"/>
              <a:ext cx="5938775" cy="3735681"/>
            </a:xfrm>
            <a:prstGeom prst="rect">
              <a:avLst/>
            </a:prstGeom>
            <a:ln>
              <a:noFill/>
            </a:ln>
            <a:effectLst>
              <a:outerShdw blurRad="190500" algn="tl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6" name="TextBox 5"/>
            <p:cNvSpPr txBox="1"/>
            <p:nvPr/>
          </p:nvSpPr>
          <p:spPr>
            <a:xfrm>
              <a:off x="3898853" y="2009940"/>
              <a:ext cx="2193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dirty="0"/>
                <a:t>GO biological process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6A4A3EF2-EAD4-40AC-8D1E-8ED60AA8264D}"/>
              </a:ext>
            </a:extLst>
          </p:cNvPr>
          <p:cNvSpPr txBox="1"/>
          <p:nvPr/>
        </p:nvSpPr>
        <p:spPr>
          <a:xfrm>
            <a:off x="1237860" y="-9629"/>
            <a:ext cx="365662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r>
              <a:rPr lang="en-US" sz="1400" b="1" dirty="0"/>
              <a:t>B         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1032093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24334E90161F04FBC841F5562821D8D" ma:contentTypeVersion="16" ma:contentTypeDescription="Create a new document." ma:contentTypeScope="" ma:versionID="44e38758809047a5e2c2dc31d72d4a3c">
  <xsd:schema xmlns:xsd="http://www.w3.org/2001/XMLSchema" xmlns:xs="http://www.w3.org/2001/XMLSchema" xmlns:p="http://schemas.microsoft.com/office/2006/metadata/properties" xmlns:ns3="4fc988d4-577e-42e9-9b2a-2c85a526e18d" xmlns:ns4="405233e3-2b02-4cc3-b510-aa513db20907" targetNamespace="http://schemas.microsoft.com/office/2006/metadata/properties" ma:root="true" ma:fieldsID="3239900a09373f0588aa0b76780cbbb1" ns3:_="" ns4:_="">
    <xsd:import namespace="4fc988d4-577e-42e9-9b2a-2c85a526e18d"/>
    <xsd:import namespace="405233e3-2b02-4cc3-b510-aa513db2090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fc988d4-577e-42e9-9b2a-2c85a526e18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LengthInSeconds" ma:index="17" nillable="true" ma:displayName="Length (seconds)" ma:internalName="MediaLengthInSeconds" ma:readOnly="true">
      <xsd:simpleType>
        <xsd:restriction base="dms:Unknown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05233e3-2b02-4cc3-b510-aa513db20907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fc988d4-577e-42e9-9b2a-2c85a526e18d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F0BBDC4-C51B-4DC2-B21C-6056462F94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fc988d4-577e-42e9-9b2a-2c85a526e18d"/>
    <ds:schemaRef ds:uri="405233e3-2b02-4cc3-b510-aa513db2090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3506DFF-1E26-445F-B80C-746E93E25B55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405233e3-2b02-4cc3-b510-aa513db20907"/>
    <ds:schemaRef ds:uri="4fc988d4-577e-42e9-9b2a-2c85a526e18d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096B0C72-EA42-41F5-9936-412B1701F8F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64</TotalTime>
  <Words>848</Words>
  <Application>Microsoft Office PowerPoint</Application>
  <PresentationFormat>Widescreen</PresentationFormat>
  <Paragraphs>14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13232758</dc:creator>
  <cp:lastModifiedBy>Gupta, Sanjeev</cp:lastModifiedBy>
  <cp:revision>370</cp:revision>
  <cp:lastPrinted>2018-04-25T09:24:38Z</cp:lastPrinted>
  <dcterms:created xsi:type="dcterms:W3CDTF">2018-03-08T15:38:46Z</dcterms:created>
  <dcterms:modified xsi:type="dcterms:W3CDTF">2023-10-11T18:00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24334E90161F04FBC841F5562821D8D</vt:lpwstr>
  </property>
</Properties>
</file>